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28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5.png" ContentType="image/png"/>
  <Override PartName="/ppt/media/image35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presProps.xml" ContentType="application/vnd.openxmlformats-officedocument.presentationml.presProps+xml"/>
  <Override PartName="/ppt/slides/slide56.xml" ContentType="application/vnd.openxmlformats-officedocument.presentationml.slide+xml"/>
  <Override PartName="/ppt/slides/slide55.xml" ContentType="application/vnd.openxmlformats-officedocument.presentationml.slide+xml"/>
  <Override PartName="/ppt/slides/slide54.xml" ContentType="application/vnd.openxmlformats-officedocument.presentationml.slide+xml"/>
  <Override PartName="/ppt/slides/slide53.xml" ContentType="application/vnd.openxmlformats-officedocument.presentationml.slide+xml"/>
  <Override PartName="/ppt/slides/slide52.xml" ContentType="application/vnd.openxmlformats-officedocument.presentationml.slide+xml"/>
  <Override PartName="/ppt/slides/slide51.xml" ContentType="application/vnd.openxmlformats-officedocument.presentationml.slide+xml"/>
  <Override PartName="/ppt/slides/slide50.xml" ContentType="application/vnd.openxmlformats-officedocument.presentationml.slide+xml"/>
  <Override PartName="/ppt/slides/slide46.xml" ContentType="application/vnd.openxmlformats-officedocument.presentationml.slide+xml"/>
  <Override PartName="/ppt/slides/slide45.xml" ContentType="application/vnd.openxmlformats-officedocument.presentationml.slide+xml"/>
  <Override PartName="/ppt/slides/slide39.xml" ContentType="application/vnd.openxmlformats-officedocument.presentationml.slide+xml"/>
  <Override PartName="/ppt/slides/slide38.xml" ContentType="application/vnd.openxmlformats-officedocument.presentationml.slide+xml"/>
  <Override PartName="/ppt/slides/slide37.xml" ContentType="application/vnd.openxmlformats-officedocument.presentationml.slide+xml"/>
  <Override PartName="/ppt/slides/slide36.xml" ContentType="application/vnd.openxmlformats-officedocument.presentationml.slide+xml"/>
  <Override PartName="/ppt/slides/slide35.xml" ContentType="application/vnd.openxmlformats-officedocument.presentationml.slide+xml"/>
  <Override PartName="/ppt/slides/slide34.xml" ContentType="application/vnd.openxmlformats-officedocument.presentationml.slide+xml"/>
  <Override PartName="/ppt/slides/slide33.xml" ContentType="application/vnd.openxmlformats-officedocument.presentationml.slide+xml"/>
  <Override PartName="/ppt/slides/slide32.xml" ContentType="application/vnd.openxmlformats-officedocument.presentationml.slide+xml"/>
  <Override PartName="/ppt/slides/slide31.xml" ContentType="application/vnd.openxmlformats-officedocument.presentationml.slide+xml"/>
  <Override PartName="/ppt/slides/slide30.xml" ContentType="application/vnd.openxmlformats-officedocument.presentationml.slide+xml"/>
  <Override PartName="/ppt/slides/_rels/slide41.xml.rels" ContentType="application/vnd.openxmlformats-package.relationships+xml"/>
  <Override PartName="/ppt/slides/_rels/slide6.xml.rels" ContentType="application/vnd.openxmlformats-package.relationships+xml"/>
  <Override PartName="/ppt/slides/_rels/slide18.xml.rels" ContentType="application/vnd.openxmlformats-package.relationships+xml"/>
  <Override PartName="/ppt/slides/_rels/slide22.xml.rels" ContentType="application/vnd.openxmlformats-package.relationships+xml"/>
  <Override PartName="/ppt/slides/_rels/slide1.xml.rels" ContentType="application/vnd.openxmlformats-package.relationships+xml"/>
  <Override PartName="/ppt/slides/_rels/slide85.xml.rels" ContentType="application/vnd.openxmlformats-package.relationships+xml"/>
  <Override PartName="/ppt/slides/_rels/slide32.xml.rels" ContentType="application/vnd.openxmlformats-package.relationships+xml"/>
  <Override PartName="/ppt/slides/_rels/slide57.xml.rels" ContentType="application/vnd.openxmlformats-package.relationships+xml"/>
  <Override PartName="/ppt/slides/_rels/slide61.xml.rels" ContentType="application/vnd.openxmlformats-package.relationships+xml"/>
  <Override PartName="/ppt/slides/_rels/slide20.xml.rels" ContentType="application/vnd.openxmlformats-package.relationships+xml"/>
  <Override PartName="/ppt/slides/_rels/slide16.xml.rels" ContentType="application/vnd.openxmlformats-package.relationships+xml"/>
  <Override PartName="/ppt/slides/_rels/slide19.xml.rels" ContentType="application/vnd.openxmlformats-package.relationships+xml"/>
  <Override PartName="/ppt/slides/_rels/slide23.xml.rels" ContentType="application/vnd.openxmlformats-package.relationships+xml"/>
  <Override PartName="/ppt/slides/_rels/slide24.xml.rels" ContentType="application/vnd.openxmlformats-package.relationships+xml"/>
  <Override PartName="/ppt/slides/_rels/slide25.xml.rels" ContentType="application/vnd.openxmlformats-package.relationships+xml"/>
  <Override PartName="/ppt/slides/_rels/slide17.xml.rels" ContentType="application/vnd.openxmlformats-package.relationships+xml"/>
  <Override PartName="/ppt/slides/_rels/slide21.xml.rels" ContentType="application/vnd.openxmlformats-package.relationships+xml"/>
  <Override PartName="/ppt/slides/_rels/slide26.xml.rels" ContentType="application/vnd.openxmlformats-package.relationships+xml"/>
  <Override PartName="/ppt/slides/_rels/slide2.xml.rels" ContentType="application/vnd.openxmlformats-package.relationships+xml"/>
  <Override PartName="/ppt/slides/_rels/slide86.xml.rels" ContentType="application/vnd.openxmlformats-package.relationships+xml"/>
  <Override PartName="/ppt/slides/_rels/slide27.xml.rels" ContentType="application/vnd.openxmlformats-package.relationships+xml"/>
  <Override PartName="/ppt/slides/_rels/slide28.xml.rels" ContentType="application/vnd.openxmlformats-package.relationships+xml"/>
  <Override PartName="/ppt/slides/_rels/slide14.xml.rels" ContentType="application/vnd.openxmlformats-package.relationships+xml"/>
  <Override PartName="/ppt/slides/_rels/slide89.xml.rels" ContentType="application/vnd.openxmlformats-package.relationships+xml"/>
  <Override PartName="/ppt/slides/_rels/slide29.xml.rels" ContentType="application/vnd.openxmlformats-package.relationships+xml"/>
  <Override PartName="/ppt/slides/_rels/slide33.xml.rels" ContentType="application/vnd.openxmlformats-package.relationships+xml"/>
  <Override PartName="/ppt/slides/_rels/slide94.xml.rels" ContentType="application/vnd.openxmlformats-package.relationships+xml"/>
  <Override PartName="/ppt/slides/_rels/slide87.xml.rels" ContentType="application/vnd.openxmlformats-package.relationships+xml"/>
  <Override PartName="/ppt/slides/_rels/slide3.xml.rels" ContentType="application/vnd.openxmlformats-package.relationships+xml"/>
  <Override PartName="/ppt/slides/_rels/slide72.xml.rels" ContentType="application/vnd.openxmlformats-package.relationships+xml"/>
  <Override PartName="/ppt/slides/_rels/slide68.xml.rels" ContentType="application/vnd.openxmlformats-package.relationships+xml"/>
  <Override PartName="/ppt/slides/_rels/slide78.xml.rels" ContentType="application/vnd.openxmlformats-package.relationships+xml"/>
  <Override PartName="/ppt/slides/_rels/slide79.xml.rels" ContentType="application/vnd.openxmlformats-package.relationships+xml"/>
  <Override PartName="/ppt/slides/_rels/slide83.xml.rels" ContentType="application/vnd.openxmlformats-package.relationships+xml"/>
  <Override PartName="/ppt/slides/_rels/slide30.xml.rels" ContentType="application/vnd.openxmlformats-package.relationships+xml"/>
  <Override PartName="/ppt/slides/_rels/slide95.xml.rels" ContentType="application/vnd.openxmlformats-package.relationships+xml"/>
  <Override PartName="/ppt/slides/_rels/slide88.xml.rels" ContentType="application/vnd.openxmlformats-package.relationships+xml"/>
  <Override PartName="/ppt/slides/_rels/slide73.xml.rels" ContentType="application/vnd.openxmlformats-package.relationships+xml"/>
  <Override PartName="/ppt/slides/_rels/slide69.xml.rels" ContentType="application/vnd.openxmlformats-package.relationships+xml"/>
  <Override PartName="/ppt/slides/_rels/slide7.xml.rels" ContentType="application/vnd.openxmlformats-package.relationships+xml"/>
  <Override PartName="/ppt/slides/_rels/slide42.xml.rels" ContentType="application/vnd.openxmlformats-package.relationships+xml"/>
  <Override PartName="/ppt/slides/_rels/slide35.xml.rels" ContentType="application/vnd.openxmlformats-package.relationships+xml"/>
  <Override PartName="/ppt/slides/_rels/slide51.xml.rels" ContentType="application/vnd.openxmlformats-package.relationships+xml"/>
  <Override PartName="/ppt/slides/_rels/slide63.xml.rels" ContentType="application/vnd.openxmlformats-package.relationships+xml"/>
  <Override PartName="/ppt/slides/_rels/slide47.xml.rels" ContentType="application/vnd.openxmlformats-package.relationships+xml"/>
  <Override PartName="/ppt/slides/_rels/slide54.xml.rels" ContentType="application/vnd.openxmlformats-package.relationships+xml"/>
  <Override PartName="/ppt/slides/_rels/slide4.xml.rels" ContentType="application/vnd.openxmlformats-package.relationships+xml"/>
  <Override PartName="/ppt/slides/_rels/slide70.xml.rels" ContentType="application/vnd.openxmlformats-package.relationships+xml"/>
  <Override PartName="/ppt/slides/_rels/slide100.xml.rels" ContentType="application/vnd.openxmlformats-package.relationships+xml"/>
  <Override PartName="/ppt/slides/_rels/slide77.xml.rels" ContentType="application/vnd.openxmlformats-package.relationships+xml"/>
  <Override PartName="/ppt/slides/_rels/slide93.xml.rels" ContentType="application/vnd.openxmlformats-package.relationships+xml"/>
  <Override PartName="/ppt/slides/_rels/slide15.xml.rels" ContentType="application/vnd.openxmlformats-package.relationships+xml"/>
  <Override PartName="/ppt/slides/_rels/slide39.xml.rels" ContentType="application/vnd.openxmlformats-package.relationships+xml"/>
  <Override PartName="/ppt/slides/_rels/slide80.xml.rels" ContentType="application/vnd.openxmlformats-package.relationships+xml"/>
  <Override PartName="/ppt/slides/_rels/slide11.xml.rels" ContentType="application/vnd.openxmlformats-package.relationships+xml"/>
  <Override PartName="/ppt/slides/_rels/slide64.xml.rels" ContentType="application/vnd.openxmlformats-package.relationships+xml"/>
  <Override PartName="/ppt/slides/_rels/slide48.xml.rels" ContentType="application/vnd.openxmlformats-package.relationships+xml"/>
  <Override PartName="/ppt/slides/_rels/slide55.xml.rels" ContentType="application/vnd.openxmlformats-package.relationships+xml"/>
  <Override PartName="/ppt/slides/_rels/slide5.xml.rels" ContentType="application/vnd.openxmlformats-package.relationships+xml"/>
  <Override PartName="/ppt/slides/_rels/slide40.xml.rels" ContentType="application/vnd.openxmlformats-package.relationships+xml"/>
  <Override PartName="/ppt/slides/_rels/slide81.xml.rels" ContentType="application/vnd.openxmlformats-package.relationships+xml"/>
  <Override PartName="/ppt/slides/_rels/slide65.xml.rels" ContentType="application/vnd.openxmlformats-package.relationships+xml"/>
  <Override PartName="/ppt/slides/_rels/slide74.xml.rels" ContentType="application/vnd.openxmlformats-package.relationships+xml"/>
  <Override PartName="/ppt/slides/_rels/slide58.xml.rels" ContentType="application/vnd.openxmlformats-package.relationships+xml"/>
  <Override PartName="/ppt/slides/_rels/slide12.xml.rels" ContentType="application/vnd.openxmlformats-package.relationships+xml"/>
  <Override PartName="/ppt/slides/_rels/slide49.xml.rels" ContentType="application/vnd.openxmlformats-package.relationships+xml"/>
  <Override PartName="/ppt/slides/_rels/slide34.xml.rels" ContentType="application/vnd.openxmlformats-package.relationships+xml"/>
  <Override PartName="/ppt/slides/_rels/slide53.xml.rels" ContentType="application/vnd.openxmlformats-package.relationships+xml"/>
  <Override PartName="/ppt/slides/_rels/slide62.xml.rels" ContentType="application/vnd.openxmlformats-package.relationships+xml"/>
  <Override PartName="/ppt/slides/_rels/slide46.xml.rels" ContentType="application/vnd.openxmlformats-package.relationships+xml"/>
  <Override PartName="/ppt/slides/_rels/slide52.xml.rels" ContentType="application/vnd.openxmlformats-package.relationships+xml"/>
  <Override PartName="/ppt/slides/_rels/slide76.xml.rels" ContentType="application/vnd.openxmlformats-package.relationships+xml"/>
  <Override PartName="/ppt/slides/_rels/slide71.xml.rels" ContentType="application/vnd.openxmlformats-package.relationships+xml"/>
  <Override PartName="/ppt/slides/_rels/slide67.xml.rels" ContentType="application/vnd.openxmlformats-package.relationships+xml"/>
  <Override PartName="/ppt/slides/_rels/slide13.xml.rels" ContentType="application/vnd.openxmlformats-package.relationships+xml"/>
  <Override PartName="/ppt/slides/_rels/slide38.xml.rels" ContentType="application/vnd.openxmlformats-package.relationships+xml"/>
  <Override PartName="/ppt/slides/_rels/slide37.xml.rels" ContentType="application/vnd.openxmlformats-package.relationships+xml"/>
  <Override PartName="/ppt/slides/_rels/slide36.xml.rels" ContentType="application/vnd.openxmlformats-package.relationships+xml"/>
  <Override PartName="/ppt/slides/_rels/slide96.xml.rels" ContentType="application/vnd.openxmlformats-package.relationships+xml"/>
  <Override PartName="/ppt/slides/_rels/slide8.xml.rels" ContentType="application/vnd.openxmlformats-package.relationships+xml"/>
  <Override PartName="/ppt/slides/_rels/slide43.xml.rels" ContentType="application/vnd.openxmlformats-package.relationships+xml"/>
  <Override PartName="/ppt/slides/_rels/slide66.xml.rels" ContentType="application/vnd.openxmlformats-package.relationships+xml"/>
  <Override PartName="/ppt/slides/_rels/slide75.xml.rels" ContentType="application/vnd.openxmlformats-package.relationships+xml"/>
  <Override PartName="/ppt/slides/_rels/slide56.xml.rels" ContentType="application/vnd.openxmlformats-package.relationships+xml"/>
  <Override PartName="/ppt/slides/_rels/slide60.xml.rels" ContentType="application/vnd.openxmlformats-package.relationships+xml"/>
  <Override PartName="/ppt/slides/_rels/slide82.xml.rels" ContentType="application/vnd.openxmlformats-package.relationships+xml"/>
  <Override PartName="/ppt/slides/_rels/slide59.xml.rels" ContentType="application/vnd.openxmlformats-package.relationships+xml"/>
  <Override PartName="/ppt/slides/_rels/slide10.xml.rels" ContentType="application/vnd.openxmlformats-package.relationships+xml"/>
  <Override PartName="/ppt/slides/_rels/slide50.xml.rels" ContentType="application/vnd.openxmlformats-package.relationships+xml"/>
  <Override PartName="/ppt/slides/_rels/slide99.xml.rels" ContentType="application/vnd.openxmlformats-package.relationships+xml"/>
  <Override PartName="/ppt/slides/_rels/slide91.xml.rels" ContentType="application/vnd.openxmlformats-package.relationships+xml"/>
  <Override PartName="/ppt/slides/_rels/slide31.xml.rels" ContentType="application/vnd.openxmlformats-package.relationships+xml"/>
  <Override PartName="/ppt/slides/_rels/slide84.xml.rels" ContentType="application/vnd.openxmlformats-package.relationships+xml"/>
  <Override PartName="/ppt/slides/_rels/slide45.xml.rels" ContentType="application/vnd.openxmlformats-package.relationships+xml"/>
  <Override PartName="/ppt/slides/_rels/slide98.xml.rels" ContentType="application/vnd.openxmlformats-package.relationships+xml"/>
  <Override PartName="/ppt/slides/_rels/slide90.xml.rels" ContentType="application/vnd.openxmlformats-package.relationships+xml"/>
  <Override PartName="/ppt/slides/_rels/slide92.xml.rels" ContentType="application/vnd.openxmlformats-package.relationships+xml"/>
  <Override PartName="/ppt/slides/_rels/slide44.xml.rels" ContentType="application/vnd.openxmlformats-package.relationships+xml"/>
  <Override PartName="/ppt/slides/_rels/slide9.xml.rels" ContentType="application/vnd.openxmlformats-package.relationships+xml"/>
  <Override PartName="/ppt/slides/_rels/slide97.xml.rels" ContentType="application/vnd.openxmlformats-package.relationships+xml"/>
  <Override PartName="/ppt/slides/slide13.xml" ContentType="application/vnd.openxmlformats-officedocument.presentationml.slide+xml"/>
  <Override PartName="/ppt/slides/slide6.xml" ContentType="application/vnd.openxmlformats-officedocument.presentationml.slide+xml"/>
  <Override PartName="/ppt/slides/slide49.xml" ContentType="application/vnd.openxmlformats-officedocument.presentationml.slide+xml"/>
  <Override PartName="/ppt/slides/slide12.xml" ContentType="application/vnd.openxmlformats-officedocument.presentationml.slide+xml"/>
  <Override PartName="/ppt/slides/slide5.xml" ContentType="application/vnd.openxmlformats-officedocument.presentationml.slide+xml"/>
  <Override PartName="/ppt/slides/slide44.xml" ContentType="application/vnd.openxmlformats-officedocument.presentationml.slide+xml"/>
  <Override PartName="/ppt/slides/slide9.xml" ContentType="application/vnd.openxmlformats-officedocument.presentationml.slide+xml"/>
  <Override PartName="/ppt/slides/slide16.xml" ContentType="application/vnd.openxmlformats-officedocument.presentationml.slide+xml"/>
  <Override PartName="/ppt/slides/slide81.xml" ContentType="application/vnd.openxmlformats-officedocument.presentationml.slide+xml"/>
  <Override PartName="/ppt/slides/slide48.xml" ContentType="application/vnd.openxmlformats-officedocument.presentationml.slide+xml"/>
  <Override PartName="/ppt/slides/slide11.xml" ContentType="application/vnd.openxmlformats-officedocument.presentationml.slide+xml"/>
  <Override PartName="/ppt/slides/slide4.xml" ContentType="application/vnd.openxmlformats-officedocument.presentationml.slide+xml"/>
  <Override PartName="/ppt/slides/slide43.xml" ContentType="application/vnd.openxmlformats-officedocument.presentationml.slide+xml"/>
  <Override PartName="/ppt/slides/slide8.xml" ContentType="application/vnd.openxmlformats-officedocument.presentationml.slide+xml"/>
  <Override PartName="/ppt/slides/slide15.xml" ContentType="application/vnd.openxmlformats-officedocument.presentationml.slide+xml"/>
  <Override PartName="/ppt/slides/slide80.xml" ContentType="application/vnd.openxmlformats-officedocument.presentationml.slide+xml"/>
  <Override PartName="/ppt/slides/slide47.xml" ContentType="application/vnd.openxmlformats-officedocument.presentationml.slide+xml"/>
  <Override PartName="/ppt/slides/slide100.xml" ContentType="application/vnd.openxmlformats-officedocument.presentationml.slide+xml"/>
  <Override PartName="/ppt/slides/slide10.xml" ContentType="application/vnd.openxmlformats-officedocument.presentationml.slide+xml"/>
  <Override PartName="/ppt/slides/slide3.xml" ContentType="application/vnd.openxmlformats-officedocument.presentationml.slide+xml"/>
  <Override PartName="/ppt/slides/slide42.xml" ContentType="application/vnd.openxmlformats-officedocument.presentationml.slide+xml"/>
  <Override PartName="/ppt/slides/slide65.xml" ContentType="application/vnd.openxmlformats-officedocument.presentationml.slide+xml"/>
  <Override PartName="/ppt/slides/slide66.xml" ContentType="application/vnd.openxmlformats-officedocument.presentationml.slide+xml"/>
  <Override PartName="/ppt/slides/slide67.xml" ContentType="application/vnd.openxmlformats-officedocument.presentationml.slide+xml"/>
  <Override PartName="/ppt/slides/slide68.xml" ContentType="application/vnd.openxmlformats-officedocument.presentationml.slide+xml"/>
  <Override PartName="/ppt/slides/slide70.xml" ContentType="application/vnd.openxmlformats-officedocument.presentationml.slide+xml"/>
  <Override PartName="/ppt/slides/slide69.xml" ContentType="application/vnd.openxmlformats-officedocument.presentationml.slide+xml"/>
  <Override PartName="/ppt/slides/slide71.xml" ContentType="application/vnd.openxmlformats-officedocument.presentationml.slide+xml"/>
  <Override PartName="/ppt/slides/slide72.xml" ContentType="application/vnd.openxmlformats-officedocument.presentationml.slide+xml"/>
  <Override PartName="/ppt/slides/slide73.xml" ContentType="application/vnd.openxmlformats-officedocument.presentationml.slide+xml"/>
  <Override PartName="/ppt/slides/slide1.xml" ContentType="application/vnd.openxmlformats-officedocument.presentationml.slide+xml"/>
  <Override PartName="/ppt/slides/slide74.xml" ContentType="application/vnd.openxmlformats-officedocument.presentationml.slide+xml"/>
  <Override PartName="/ppt/slides/slide2.xml" ContentType="application/vnd.openxmlformats-officedocument.presentationml.slide+xml"/>
  <Override PartName="/ppt/slides/slide75.xml" ContentType="application/vnd.openxmlformats-officedocument.presentationml.slide+xml"/>
  <Override PartName="/ppt/slides/slide76.xml" ContentType="application/vnd.openxmlformats-officedocument.presentationml.slide+xml"/>
  <Override PartName="/ppt/slides/slide64.xml" ContentType="application/vnd.openxmlformats-officedocument.presentationml.slide+xml"/>
  <Override PartName="/ppt/slides/slide99.xml" ContentType="application/vnd.openxmlformats-officedocument.presentationml.slide+xml"/>
  <Override PartName="/ppt/slides/slide62.xml" ContentType="application/vnd.openxmlformats-officedocument.presentationml.slide+xml"/>
  <Override PartName="/ppt/slides/slide87.xml" ContentType="application/vnd.openxmlformats-officedocument.presentationml.slide+xml"/>
  <Override PartName="/ppt/slides/slide63.xml" ContentType="application/vnd.openxmlformats-officedocument.presentationml.slide+xml"/>
  <Override PartName="/ppt/slides/slide98.xml" ContentType="application/vnd.openxmlformats-officedocument.presentationml.slide+xml"/>
  <Override PartName="/ppt/slides/slide61.xml" ContentType="application/vnd.openxmlformats-officedocument.presentationml.slide+xml"/>
  <Override PartName="/ppt/slides/slide86.xml" ContentType="application/vnd.openxmlformats-officedocument.presentationml.slide+xml"/>
  <Override PartName="/ppt/slides/slide97.xml" ContentType="application/vnd.openxmlformats-officedocument.presentationml.slide+xml"/>
  <Override PartName="/ppt/slides/slide60.xml" ContentType="application/vnd.openxmlformats-officedocument.presentationml.slide+xml"/>
  <Override PartName="/ppt/slides/slide85.xml" ContentType="application/vnd.openxmlformats-officedocument.presentationml.slide+xml"/>
  <Override PartName="/ppt/slides/slide96.xml" ContentType="application/vnd.openxmlformats-officedocument.presentationml.slide+xml"/>
  <Override PartName="/ppt/slides/slide95.xml" ContentType="application/vnd.openxmlformats-officedocument.presentationml.slide+xml"/>
  <Override PartName="/ppt/slides/slide89.xml" ContentType="application/vnd.openxmlformats-officedocument.presentationml.slide+xml"/>
  <Override PartName="/ppt/slides/slide77.xml" ContentType="application/vnd.openxmlformats-officedocument.presentationml.slide+xml"/>
  <Override PartName="/ppt/slides/slide40.xml" ContentType="application/vnd.openxmlformats-officedocument.presentationml.slide+xml"/>
  <Override PartName="/ppt/slides/slide88.xml" ContentType="application/vnd.openxmlformats-officedocument.presentationml.slide+xml"/>
  <Override PartName="/ppt/slides/slide79.xml" ContentType="application/vnd.openxmlformats-officedocument.presentationml.slide+xml"/>
  <Override PartName="/ppt/slides/slide78.xml" ContentType="application/vnd.openxmlformats-officedocument.presentationml.slide+xml"/>
  <Override PartName="/ppt/slides/slide41.xml" ContentType="application/vnd.openxmlformats-officedocument.presentationml.slide+xml"/>
  <Override PartName="/ppt/slides/slide29.xml" ContentType="application/vnd.openxmlformats-officedocument.presentationml.slide+xml"/>
  <Override PartName="/ppt/slides/slide94.xml" ContentType="application/vnd.openxmlformats-officedocument.presentationml.slide+xml"/>
  <Override PartName="/ppt/slides/slide28.xml" ContentType="application/vnd.openxmlformats-officedocument.presentationml.slide+xml"/>
  <Override PartName="/ppt/slides/slide93.xml" ContentType="application/vnd.openxmlformats-officedocument.presentationml.slide+xml"/>
  <Override PartName="/ppt/slides/slide7.xml" ContentType="application/vnd.openxmlformats-officedocument.presentationml.slide+xml"/>
  <Override PartName="/ppt/slides/slide14.xml" ContentType="application/vnd.openxmlformats-officedocument.presentationml.slide+xml"/>
  <Override PartName="/ppt/slides/slide92.xml" ContentType="application/vnd.openxmlformats-officedocument.presentationml.slide+xml"/>
  <Override PartName="/ppt/slides/slide27.xml" ContentType="application/vnd.openxmlformats-officedocument.presentationml.slide+xml"/>
  <Override PartName="/ppt/slides/slide91.xml" ContentType="application/vnd.openxmlformats-officedocument.presentationml.slide+xml"/>
  <Override PartName="/ppt/slides/slide26.xml" ContentType="application/vnd.openxmlformats-officedocument.presentationml.slide+xml"/>
  <Override PartName="/ppt/slides/slide90.xml" ContentType="application/vnd.openxmlformats-officedocument.presentationml.slide+xml"/>
  <Override PartName="/ppt/slides/slide25.xml" ContentType="application/vnd.openxmlformats-officedocument.presentationml.slide+xml"/>
  <Override PartName="/ppt/slides/slide24.xml" ContentType="application/vnd.openxmlformats-officedocument.presentationml.slide+xml"/>
  <Override PartName="/ppt/slides/slide23.xml" ContentType="application/vnd.openxmlformats-officedocument.presentationml.slide+xml"/>
  <Override PartName="/ppt/slides/slide22.xml" ContentType="application/vnd.openxmlformats-officedocument.presentationml.slide+xml"/>
  <Override PartName="/ppt/slides/slide59.xml" ContentType="application/vnd.openxmlformats-officedocument.presentationml.slide+xml"/>
  <Override PartName="/ppt/slides/slide21.xml" ContentType="application/vnd.openxmlformats-officedocument.presentationml.slide+xml"/>
  <Override PartName="/ppt/slides/slide58.xml" ContentType="application/vnd.openxmlformats-officedocument.presentationml.slide+xml"/>
  <Override PartName="/ppt/slides/slide19.xml" ContentType="application/vnd.openxmlformats-officedocument.presentationml.slide+xml"/>
  <Override PartName="/ppt/slides/slide84.xml" ContentType="application/vnd.openxmlformats-officedocument.presentationml.slide+xml"/>
  <Override PartName="/ppt/slides/slide20.xml" ContentType="application/vnd.openxmlformats-officedocument.presentationml.slide+xml"/>
  <Override PartName="/ppt/slides/slide57.xml" ContentType="application/vnd.openxmlformats-officedocument.presentationml.slide+xml"/>
  <Override PartName="/ppt/slides/slide18.xml" ContentType="application/vnd.openxmlformats-officedocument.presentationml.slide+xml"/>
  <Override PartName="/ppt/slides/slide83.xml" ContentType="application/vnd.openxmlformats-officedocument.presentationml.slide+xml"/>
  <Override PartName="/ppt/slides/slide17.xml" ContentType="application/vnd.openxmlformats-officedocument.presentationml.slide+xml"/>
  <Override PartName="/ppt/slides/slide8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  <p:sldId id="273" r:id="rId20"/>
    <p:sldId id="274" r:id="rId21"/>
    <p:sldId id="275" r:id="rId22"/>
    <p:sldId id="276" r:id="rId23"/>
    <p:sldId id="277" r:id="rId24"/>
    <p:sldId id="278" r:id="rId25"/>
    <p:sldId id="279" r:id="rId26"/>
    <p:sldId id="280" r:id="rId27"/>
    <p:sldId id="281" r:id="rId28"/>
    <p:sldId id="282" r:id="rId29"/>
    <p:sldId id="283" r:id="rId30"/>
    <p:sldId id="284" r:id="rId31"/>
    <p:sldId id="285" r:id="rId32"/>
    <p:sldId id="286" r:id="rId33"/>
    <p:sldId id="287" r:id="rId34"/>
    <p:sldId id="288" r:id="rId35"/>
    <p:sldId id="289" r:id="rId36"/>
    <p:sldId id="290" r:id="rId37"/>
    <p:sldId id="291" r:id="rId38"/>
    <p:sldId id="292" r:id="rId39"/>
    <p:sldId id="293" r:id="rId40"/>
    <p:sldId id="294" r:id="rId41"/>
    <p:sldId id="295" r:id="rId42"/>
    <p:sldId id="296" r:id="rId43"/>
    <p:sldId id="297" r:id="rId44"/>
    <p:sldId id="298" r:id="rId45"/>
    <p:sldId id="299" r:id="rId46"/>
    <p:sldId id="300" r:id="rId47"/>
    <p:sldId id="301" r:id="rId48"/>
    <p:sldId id="302" r:id="rId49"/>
    <p:sldId id="303" r:id="rId50"/>
    <p:sldId id="304" r:id="rId51"/>
    <p:sldId id="305" r:id="rId52"/>
    <p:sldId id="306" r:id="rId53"/>
    <p:sldId id="307" r:id="rId54"/>
    <p:sldId id="308" r:id="rId55"/>
    <p:sldId id="309" r:id="rId56"/>
    <p:sldId id="310" r:id="rId57"/>
    <p:sldId id="311" r:id="rId58"/>
    <p:sldId id="312" r:id="rId59"/>
    <p:sldId id="313" r:id="rId60"/>
    <p:sldId id="314" r:id="rId61"/>
    <p:sldId id="315" r:id="rId62"/>
    <p:sldId id="316" r:id="rId63"/>
    <p:sldId id="317" r:id="rId64"/>
    <p:sldId id="318" r:id="rId65"/>
    <p:sldId id="319" r:id="rId66"/>
    <p:sldId id="320" r:id="rId67"/>
    <p:sldId id="321" r:id="rId68"/>
    <p:sldId id="322" r:id="rId69"/>
    <p:sldId id="323" r:id="rId70"/>
    <p:sldId id="324" r:id="rId71"/>
    <p:sldId id="325" r:id="rId72"/>
    <p:sldId id="326" r:id="rId73"/>
    <p:sldId id="327" r:id="rId74"/>
    <p:sldId id="328" r:id="rId75"/>
    <p:sldId id="329" r:id="rId76"/>
    <p:sldId id="330" r:id="rId77"/>
    <p:sldId id="331" r:id="rId78"/>
    <p:sldId id="332" r:id="rId79"/>
    <p:sldId id="333" r:id="rId80"/>
    <p:sldId id="334" r:id="rId81"/>
    <p:sldId id="335" r:id="rId82"/>
    <p:sldId id="336" r:id="rId83"/>
    <p:sldId id="337" r:id="rId84"/>
    <p:sldId id="338" r:id="rId85"/>
    <p:sldId id="339" r:id="rId86"/>
    <p:sldId id="340" r:id="rId87"/>
    <p:sldId id="341" r:id="rId88"/>
    <p:sldId id="342" r:id="rId89"/>
    <p:sldId id="343" r:id="rId90"/>
    <p:sldId id="344" r:id="rId91"/>
    <p:sldId id="345" r:id="rId92"/>
    <p:sldId id="346" r:id="rId93"/>
    <p:sldId id="347" r:id="rId94"/>
    <p:sldId id="348" r:id="rId95"/>
    <p:sldId id="349" r:id="rId96"/>
    <p:sldId id="350" r:id="rId97"/>
    <p:sldId id="351" r:id="rId98"/>
    <p:sldId id="352" r:id="rId99"/>
    <p:sldId id="353" r:id="rId100"/>
    <p:sldId id="354" r:id="rId101"/>
    <p:sldId id="355" r:id="rId102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slide" Target="slides/slide18.xml"/><Relationship Id="rId21" Type="http://schemas.openxmlformats.org/officeDocument/2006/relationships/slide" Target="slides/slide19.xml"/><Relationship Id="rId22" Type="http://schemas.openxmlformats.org/officeDocument/2006/relationships/slide" Target="slides/slide20.xml"/><Relationship Id="rId23" Type="http://schemas.openxmlformats.org/officeDocument/2006/relationships/slide" Target="slides/slide21.xml"/><Relationship Id="rId24" Type="http://schemas.openxmlformats.org/officeDocument/2006/relationships/slide" Target="slides/slide22.xml"/><Relationship Id="rId25" Type="http://schemas.openxmlformats.org/officeDocument/2006/relationships/slide" Target="slides/slide23.xml"/><Relationship Id="rId26" Type="http://schemas.openxmlformats.org/officeDocument/2006/relationships/slide" Target="slides/slide24.xml"/><Relationship Id="rId27" Type="http://schemas.openxmlformats.org/officeDocument/2006/relationships/slide" Target="slides/slide25.xml"/><Relationship Id="rId28" Type="http://schemas.openxmlformats.org/officeDocument/2006/relationships/slide" Target="slides/slide26.xml"/><Relationship Id="rId29" Type="http://schemas.openxmlformats.org/officeDocument/2006/relationships/slide" Target="slides/slide27.xml"/><Relationship Id="rId30" Type="http://schemas.openxmlformats.org/officeDocument/2006/relationships/slide" Target="slides/slide28.xml"/><Relationship Id="rId31" Type="http://schemas.openxmlformats.org/officeDocument/2006/relationships/slide" Target="slides/slide29.xml"/><Relationship Id="rId32" Type="http://schemas.openxmlformats.org/officeDocument/2006/relationships/slide" Target="slides/slide30.xml"/><Relationship Id="rId33" Type="http://schemas.openxmlformats.org/officeDocument/2006/relationships/slide" Target="slides/slide31.xml"/><Relationship Id="rId34" Type="http://schemas.openxmlformats.org/officeDocument/2006/relationships/slide" Target="slides/slide32.xml"/><Relationship Id="rId35" Type="http://schemas.openxmlformats.org/officeDocument/2006/relationships/slide" Target="slides/slide33.xml"/><Relationship Id="rId36" Type="http://schemas.openxmlformats.org/officeDocument/2006/relationships/slide" Target="slides/slide34.xml"/><Relationship Id="rId37" Type="http://schemas.openxmlformats.org/officeDocument/2006/relationships/slide" Target="slides/slide35.xml"/><Relationship Id="rId38" Type="http://schemas.openxmlformats.org/officeDocument/2006/relationships/slide" Target="slides/slide36.xml"/><Relationship Id="rId39" Type="http://schemas.openxmlformats.org/officeDocument/2006/relationships/slide" Target="slides/slide37.xml"/><Relationship Id="rId40" Type="http://schemas.openxmlformats.org/officeDocument/2006/relationships/slide" Target="slides/slide38.xml"/><Relationship Id="rId41" Type="http://schemas.openxmlformats.org/officeDocument/2006/relationships/slide" Target="slides/slide39.xml"/><Relationship Id="rId42" Type="http://schemas.openxmlformats.org/officeDocument/2006/relationships/slide" Target="slides/slide40.xml"/><Relationship Id="rId43" Type="http://schemas.openxmlformats.org/officeDocument/2006/relationships/slide" Target="slides/slide41.xml"/><Relationship Id="rId44" Type="http://schemas.openxmlformats.org/officeDocument/2006/relationships/slide" Target="slides/slide42.xml"/><Relationship Id="rId45" Type="http://schemas.openxmlformats.org/officeDocument/2006/relationships/slide" Target="slides/slide43.xml"/><Relationship Id="rId46" Type="http://schemas.openxmlformats.org/officeDocument/2006/relationships/slide" Target="slides/slide44.xml"/><Relationship Id="rId47" Type="http://schemas.openxmlformats.org/officeDocument/2006/relationships/slide" Target="slides/slide45.xml"/><Relationship Id="rId48" Type="http://schemas.openxmlformats.org/officeDocument/2006/relationships/slide" Target="slides/slide46.xml"/><Relationship Id="rId49" Type="http://schemas.openxmlformats.org/officeDocument/2006/relationships/slide" Target="slides/slide47.xml"/><Relationship Id="rId50" Type="http://schemas.openxmlformats.org/officeDocument/2006/relationships/slide" Target="slides/slide48.xml"/><Relationship Id="rId51" Type="http://schemas.openxmlformats.org/officeDocument/2006/relationships/slide" Target="slides/slide49.xml"/><Relationship Id="rId52" Type="http://schemas.openxmlformats.org/officeDocument/2006/relationships/slide" Target="slides/slide50.xml"/><Relationship Id="rId53" Type="http://schemas.openxmlformats.org/officeDocument/2006/relationships/slide" Target="slides/slide51.xml"/><Relationship Id="rId54" Type="http://schemas.openxmlformats.org/officeDocument/2006/relationships/slide" Target="slides/slide52.xml"/><Relationship Id="rId55" Type="http://schemas.openxmlformats.org/officeDocument/2006/relationships/slide" Target="slides/slide53.xml"/><Relationship Id="rId56" Type="http://schemas.openxmlformats.org/officeDocument/2006/relationships/slide" Target="slides/slide54.xml"/><Relationship Id="rId57" Type="http://schemas.openxmlformats.org/officeDocument/2006/relationships/slide" Target="slides/slide55.xml"/><Relationship Id="rId58" Type="http://schemas.openxmlformats.org/officeDocument/2006/relationships/slide" Target="slides/slide56.xml"/><Relationship Id="rId59" Type="http://schemas.openxmlformats.org/officeDocument/2006/relationships/slide" Target="slides/slide57.xml"/><Relationship Id="rId60" Type="http://schemas.openxmlformats.org/officeDocument/2006/relationships/slide" Target="slides/slide58.xml"/><Relationship Id="rId61" Type="http://schemas.openxmlformats.org/officeDocument/2006/relationships/slide" Target="slides/slide59.xml"/><Relationship Id="rId62" Type="http://schemas.openxmlformats.org/officeDocument/2006/relationships/slide" Target="slides/slide60.xml"/><Relationship Id="rId63" Type="http://schemas.openxmlformats.org/officeDocument/2006/relationships/slide" Target="slides/slide61.xml"/><Relationship Id="rId64" Type="http://schemas.openxmlformats.org/officeDocument/2006/relationships/slide" Target="slides/slide62.xml"/><Relationship Id="rId65" Type="http://schemas.openxmlformats.org/officeDocument/2006/relationships/slide" Target="slides/slide63.xml"/><Relationship Id="rId66" Type="http://schemas.openxmlformats.org/officeDocument/2006/relationships/slide" Target="slides/slide64.xml"/><Relationship Id="rId67" Type="http://schemas.openxmlformats.org/officeDocument/2006/relationships/slide" Target="slides/slide65.xml"/><Relationship Id="rId68" Type="http://schemas.openxmlformats.org/officeDocument/2006/relationships/slide" Target="slides/slide66.xml"/><Relationship Id="rId69" Type="http://schemas.openxmlformats.org/officeDocument/2006/relationships/slide" Target="slides/slide67.xml"/><Relationship Id="rId70" Type="http://schemas.openxmlformats.org/officeDocument/2006/relationships/slide" Target="slides/slide68.xml"/><Relationship Id="rId71" Type="http://schemas.openxmlformats.org/officeDocument/2006/relationships/slide" Target="slides/slide69.xml"/><Relationship Id="rId72" Type="http://schemas.openxmlformats.org/officeDocument/2006/relationships/slide" Target="slides/slide70.xml"/><Relationship Id="rId73" Type="http://schemas.openxmlformats.org/officeDocument/2006/relationships/slide" Target="slides/slide71.xml"/><Relationship Id="rId74" Type="http://schemas.openxmlformats.org/officeDocument/2006/relationships/slide" Target="slides/slide72.xml"/><Relationship Id="rId75" Type="http://schemas.openxmlformats.org/officeDocument/2006/relationships/slide" Target="slides/slide73.xml"/><Relationship Id="rId76" Type="http://schemas.openxmlformats.org/officeDocument/2006/relationships/slide" Target="slides/slide74.xml"/><Relationship Id="rId77" Type="http://schemas.openxmlformats.org/officeDocument/2006/relationships/slide" Target="slides/slide75.xml"/><Relationship Id="rId78" Type="http://schemas.openxmlformats.org/officeDocument/2006/relationships/slide" Target="slides/slide76.xml"/><Relationship Id="rId79" Type="http://schemas.openxmlformats.org/officeDocument/2006/relationships/slide" Target="slides/slide77.xml"/><Relationship Id="rId80" Type="http://schemas.openxmlformats.org/officeDocument/2006/relationships/slide" Target="slides/slide78.xml"/><Relationship Id="rId81" Type="http://schemas.openxmlformats.org/officeDocument/2006/relationships/slide" Target="slides/slide79.xml"/><Relationship Id="rId82" Type="http://schemas.openxmlformats.org/officeDocument/2006/relationships/slide" Target="slides/slide80.xml"/><Relationship Id="rId83" Type="http://schemas.openxmlformats.org/officeDocument/2006/relationships/slide" Target="slides/slide81.xml"/><Relationship Id="rId84" Type="http://schemas.openxmlformats.org/officeDocument/2006/relationships/slide" Target="slides/slide82.xml"/><Relationship Id="rId85" Type="http://schemas.openxmlformats.org/officeDocument/2006/relationships/slide" Target="slides/slide83.xml"/><Relationship Id="rId86" Type="http://schemas.openxmlformats.org/officeDocument/2006/relationships/slide" Target="slides/slide84.xml"/><Relationship Id="rId87" Type="http://schemas.openxmlformats.org/officeDocument/2006/relationships/slide" Target="slides/slide85.xml"/><Relationship Id="rId88" Type="http://schemas.openxmlformats.org/officeDocument/2006/relationships/slide" Target="slides/slide86.xml"/><Relationship Id="rId89" Type="http://schemas.openxmlformats.org/officeDocument/2006/relationships/slide" Target="slides/slide87.xml"/><Relationship Id="rId90" Type="http://schemas.openxmlformats.org/officeDocument/2006/relationships/slide" Target="slides/slide88.xml"/><Relationship Id="rId91" Type="http://schemas.openxmlformats.org/officeDocument/2006/relationships/slide" Target="slides/slide89.xml"/><Relationship Id="rId92" Type="http://schemas.openxmlformats.org/officeDocument/2006/relationships/slide" Target="slides/slide90.xml"/><Relationship Id="rId93" Type="http://schemas.openxmlformats.org/officeDocument/2006/relationships/slide" Target="slides/slide91.xml"/><Relationship Id="rId94" Type="http://schemas.openxmlformats.org/officeDocument/2006/relationships/slide" Target="slides/slide92.xml"/><Relationship Id="rId95" Type="http://schemas.openxmlformats.org/officeDocument/2006/relationships/slide" Target="slides/slide93.xml"/><Relationship Id="rId96" Type="http://schemas.openxmlformats.org/officeDocument/2006/relationships/slide" Target="slides/slide94.xml"/><Relationship Id="rId97" Type="http://schemas.openxmlformats.org/officeDocument/2006/relationships/slide" Target="slides/slide95.xml"/><Relationship Id="rId98" Type="http://schemas.openxmlformats.org/officeDocument/2006/relationships/slide" Target="slides/slide96.xml"/><Relationship Id="rId99" Type="http://schemas.openxmlformats.org/officeDocument/2006/relationships/slide" Target="slides/slide97.xml"/><Relationship Id="rId100" Type="http://schemas.openxmlformats.org/officeDocument/2006/relationships/slide" Target="slides/slide98.xml"/><Relationship Id="rId101" Type="http://schemas.openxmlformats.org/officeDocument/2006/relationships/slide" Target="slides/slide99.xml"/><Relationship Id="rId102" Type="http://schemas.openxmlformats.org/officeDocument/2006/relationships/slide" Target="slides/slide100.xml"/><Relationship Id="rId10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61E00-2AA9-4150-9E0E-DDF9787B453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43A4BD-4A1A-4AC2-BFE6-4902A6D2E8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D0829-9462-4554-9C1D-A9BF8A7E778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4A91AF-E1BA-4662-B797-23EB3547A82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72E545-C41D-4A90-B38A-D1259784EC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3CEA0E-EF6D-42AB-B08A-F21E26286C7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DBF476-A2BE-4BCC-8207-F507B3724F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65798-94F9-4A86-9A15-47E404D86A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45FA8-A734-4107-8673-C693C8BD5FF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75B3B8-D8C3-4606-AD9C-E98B598CA5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D41A77-A9A2-4D61-9D81-DB721044AD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E0142-B3FD-42F1-8A3C-F773CBF163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F54DE8-BA17-4D6C-890F-F53C747DBDF0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0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2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2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2.xml"/>
</Relationships>
</file>

<file path=ppt/slides/_rels/slide1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1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20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2.xml"/>
</Relationships>
</file>

<file path=ppt/slides/_rels/slide2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3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2.xml"/>
</Relationships>
</file>

<file path=ppt/slides/_rels/slide2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6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2.xml"/>
</Relationships>
</file>

<file path=ppt/slides/_rels/slide2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29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2.xml"/>
</Relationships>
</file>

<file path=ppt/slides/_rels/slide3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5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2.xml"/>
</Relationships>
</file>

<file path=ppt/slides/_rels/slide3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38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2.xml"/>
</Relationships>
</file>

<file path=ppt/slides/_rels/slide3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1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2.xml"/>
</Relationships>
</file>

<file path=ppt/slides/_rels/slide4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4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2.xml"/>
</Relationships>
</file>

<file path=ppt/slides/_rels/slide4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7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2.xml"/>
</Relationships>
</file>

<file path=ppt/slides/_rels/slide4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4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2.xml"/>
</Relationships>
</file>

<file path=ppt/slides/_rels/slide50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2.xml"/>
</Relationships>
</file>

<file path=ppt/slides/_rels/slide5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3.xml.rels><?xml version="1.0" encoding="UTF-8"?>
<Relationships xmlns="http://schemas.openxmlformats.org/package/2006/relationships"><Relationship Id="rId1" Type="http://schemas.openxmlformats.org/officeDocument/2006/relationships/image" Target="../media/image18.png"/><Relationship Id="rId2" Type="http://schemas.openxmlformats.org/officeDocument/2006/relationships/slideLayout" Target="../slideLayouts/slideLayout2.xml"/>
</Relationships>
</file>

<file path=ppt/slides/_rels/slide5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6.xml.rels><?xml version="1.0" encoding="UTF-8"?>
<Relationships xmlns="http://schemas.openxmlformats.org/package/2006/relationships"><Relationship Id="rId1" Type="http://schemas.openxmlformats.org/officeDocument/2006/relationships/image" Target="../media/image19.png"/><Relationship Id="rId2" Type="http://schemas.openxmlformats.org/officeDocument/2006/relationships/slideLayout" Target="../slideLayouts/slideLayout2.xml"/>
</Relationships>
</file>

<file path=ppt/slides/_rels/slide5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59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slideLayout" Target="../slideLayouts/slideLayout2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2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slideLayout" Target="../slideLayouts/slideLayout2.xml"/>
</Relationships>
</file>

<file path=ppt/slides/_rels/slide6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5.xml.rels><?xml version="1.0" encoding="UTF-8"?>
<Relationships xmlns="http://schemas.openxmlformats.org/package/2006/relationships"><Relationship Id="rId1" Type="http://schemas.openxmlformats.org/officeDocument/2006/relationships/image" Target="../media/image22.png"/><Relationship Id="rId2" Type="http://schemas.openxmlformats.org/officeDocument/2006/relationships/slideLayout" Target="../slideLayouts/slideLayout2.xml"/>
</Relationships>
</file>

<file path=ppt/slides/_rels/slide6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68.xml.rels><?xml version="1.0" encoding="UTF-8"?>
<Relationships xmlns="http://schemas.openxmlformats.org/package/2006/relationships"><Relationship Id="rId1" Type="http://schemas.openxmlformats.org/officeDocument/2006/relationships/image" Target="../media/image23.png"/><Relationship Id="rId2" Type="http://schemas.openxmlformats.org/officeDocument/2006/relationships/slideLayout" Target="../slideLayouts/slideLayout2.xml"/>
</Relationships>
</file>

<file path=ppt/slides/_rels/slide6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1.xml.rels><?xml version="1.0" encoding="UTF-8"?>
<Relationships xmlns="http://schemas.openxmlformats.org/package/2006/relationships"><Relationship Id="rId1" Type="http://schemas.openxmlformats.org/officeDocument/2006/relationships/image" Target="../media/image24.png"/><Relationship Id="rId2" Type="http://schemas.openxmlformats.org/officeDocument/2006/relationships/slideLayout" Target="../slideLayouts/slideLayout2.xml"/>
</Relationships>
</file>

<file path=ppt/slides/_rels/slide7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3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slideLayout" Target="../slideLayouts/slideLayout3.xml"/>
</Relationships>
</file>

<file path=ppt/slides/_rels/slide74.xml.rels><?xml version="1.0" encoding="UTF-8"?>
<Relationships xmlns="http://schemas.openxmlformats.org/package/2006/relationships"><Relationship Id="rId1" Type="http://schemas.openxmlformats.org/officeDocument/2006/relationships/image" Target="../media/image26.png"/><Relationship Id="rId2" Type="http://schemas.openxmlformats.org/officeDocument/2006/relationships/slideLayout" Target="../slideLayouts/slideLayout2.xml"/>
</Relationships>
</file>

<file path=ppt/slides/_rels/slide7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7.xml.rels><?xml version="1.0" encoding="UTF-8"?>
<Relationships xmlns="http://schemas.openxmlformats.org/package/2006/relationships"><Relationship Id="rId1" Type="http://schemas.openxmlformats.org/officeDocument/2006/relationships/image" Target="../media/image27.png"/><Relationship Id="rId2" Type="http://schemas.openxmlformats.org/officeDocument/2006/relationships/slideLayout" Target="../slideLayouts/slideLayout2.xml"/>
</Relationships>
</file>

<file path=ppt/slides/_rels/slide7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7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2.xml"/>
</Relationships>
</file>

<file path=ppt/slides/_rels/slide80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slideLayout" Target="../slideLayouts/slideLayout2.xml"/>
</Relationships>
</file>

<file path=ppt/slides/_rels/slide8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3.xml.rels><?xml version="1.0" encoding="UTF-8"?>
<Relationships xmlns="http://schemas.openxmlformats.org/package/2006/relationships"><Relationship Id="rId1" Type="http://schemas.openxmlformats.org/officeDocument/2006/relationships/image" Target="../media/image29.png"/><Relationship Id="rId2" Type="http://schemas.openxmlformats.org/officeDocument/2006/relationships/slideLayout" Target="../slideLayouts/slideLayout2.xml"/>
</Relationships>
</file>

<file path=ppt/slides/_rels/slide8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5.xml.rels><?xml version="1.0" encoding="UTF-8"?>
<Relationships xmlns="http://schemas.openxmlformats.org/package/2006/relationships"><Relationship Id="rId1" Type="http://schemas.openxmlformats.org/officeDocument/2006/relationships/image" Target="../media/image30.png"/><Relationship Id="rId2" Type="http://schemas.openxmlformats.org/officeDocument/2006/relationships/slideLayout" Target="../slideLayouts/slideLayout3.xml"/>
</Relationships>
</file>

<file path=ppt/slides/_rels/slide86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slideLayout" Target="../slideLayouts/slideLayout2.xml"/>
</Relationships>
</file>

<file path=ppt/slides/_rels/slide8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89.xml.rels><?xml version="1.0" encoding="UTF-8"?>
<Relationships xmlns="http://schemas.openxmlformats.org/package/2006/relationships"><Relationship Id="rId1" Type="http://schemas.openxmlformats.org/officeDocument/2006/relationships/image" Target="../media/image32.png"/><Relationship Id="rId2" Type="http://schemas.openxmlformats.org/officeDocument/2006/relationships/slideLayout" Target="../slideLayouts/slideLayout2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2.xml.rels><?xml version="1.0" encoding="UTF-8"?>
<Relationships xmlns="http://schemas.openxmlformats.org/package/2006/relationships"><Relationship Id="rId1" Type="http://schemas.openxmlformats.org/officeDocument/2006/relationships/image" Target="../media/image33.png"/><Relationship Id="rId2" Type="http://schemas.openxmlformats.org/officeDocument/2006/relationships/slideLayout" Target="../slideLayouts/slideLayout2.xml"/>
</Relationships>
</file>

<file path=ppt/slides/_rels/slide9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5.xml.rels><?xml version="1.0" encoding="UTF-8"?>
<Relationships xmlns="http://schemas.openxmlformats.org/package/2006/relationships"><Relationship Id="rId1" Type="http://schemas.openxmlformats.org/officeDocument/2006/relationships/image" Target="../media/image34.png"/><Relationship Id="rId2" Type="http://schemas.openxmlformats.org/officeDocument/2006/relationships/slideLayout" Target="../slideLayouts/slideLayout2.xml"/>
</Relationships>
</file>

<file path=ppt/slides/_rels/slide9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_rels/slide98.xml.rels><?xml version="1.0" encoding="UTF-8"?>
<Relationships xmlns="http://schemas.openxmlformats.org/package/2006/relationships"><Relationship Id="rId1" Type="http://schemas.openxmlformats.org/officeDocument/2006/relationships/image" Target="../media/image35.png"/><Relationship Id="rId2" Type="http://schemas.openxmlformats.org/officeDocument/2006/relationships/slideLayout" Target="../slideLayouts/slideLayout2.xml"/>
</Relationships>
</file>

<file path=ppt/slides/_rels/slide9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539280" y="2852280"/>
            <a:ext cx="8915400" cy="2862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3600" spc="-1" strike="noStrike">
                <a:solidFill>
                  <a:srgbClr val="000000"/>
                </a:solidFill>
                <a:latin typeface="Arial"/>
              </a:rPr>
              <a:t>Annotated spectra for 33 differentially expressed protein spots identified by PMF </a:t>
            </a:r>
            <a:br>
              <a:rPr sz="3600"/>
            </a:b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subTitle"/>
          </p:nvPr>
        </p:nvSpPr>
        <p:spPr>
          <a:xfrm>
            <a:off x="755640" y="1341000"/>
            <a:ext cx="7448400" cy="1752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4000" spc="-1" strike="noStrike">
                <a:solidFill>
                  <a:srgbClr val="000000"/>
                </a:solidFill>
                <a:latin typeface="Arial"/>
              </a:rPr>
              <a:t>Supplemental_spectra_PMF 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-360" y="990720"/>
            <a:ext cx="9296280" cy="4876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ppm   Miss             Sequence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 - 25      2659.3140     2658.3067  2658.3743    -25         1      -.MAMAARGVLAMVVAVAVVWCNNVA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2 - 105    2645.3210     2644.3137  2644.3074      2          0               R.LGIPAYEWWSEALHGVSYVGPGTR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3 - 143    1131.6350     1130.6277  1130.5931     31         0               R.AIGEVVSTEA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44 - 164    2358.2140     2357.2067  2357.2103     -2          0               R.AMHNVGLAGLTFWSPNINIF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5 - 204    1941.9690     1940.9617  1940.9480      7          0               K.YAVGYVTGLQDAGGGSDAL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11 - 221    1411.6630     1410.6557  1410.6204     25         0               K.HYTAYDVDNW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26 - 246    2461.1790     2460.1717  2460.1486      9          0               R.YTFDAVVSQQDLDDTFQPPF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47 - 263   1903.8260      1902.8187  1902.8274     -5          0               K.SCVIDGNVASVMCSYN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20 - 342   2371.2000      2370.1927  2370.1750      7          0               K.SGLDLNCGNFLAQHTVAAVQAGK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51 - 361   1291.7410      1290.7337  1290.7118     17         0               R.AITNNFIVLM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62 - 370   1023.5110      1022.5037  1022.4822     21         0               R.LGFFDGDPR.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71 - 380   1043.6360      1042.6287  1042.6175     11         1               R.KLPFGSLGP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72 - 380    915.5470        914.5397    914.5226      19         0               K.LPFGSLGP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25 - 543   1934.0590      1933.0517  1933.0383      7          0               R.GPVILVVMSGGPFDISFA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44 - 578   3559.7980      3558.7907  3558.7896      0          1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SSDKISAILWVGYPGEAGGAALADILFGYHNPGGR.L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48 - 578   3142.6100      3141.6027  3141.6036     -0          0 K.ISAILWVGYPGEAGGAALADILFGYHNPGG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79 - 591   1494.7950      1493.7877  1493.7555     22         0              R.LPVTWYPASFAD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14 - 631   2004.9390      2003.9317  2003.9153      8          0              R.FYTGDTVYAFGDGLSYTK.F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/>
          </p:nvPr>
        </p:nvSpPr>
        <p:spPr>
          <a:xfrm>
            <a:off x="0" y="1142640"/>
            <a:ext cx="9144000" cy="2133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 Mr(expt)    Mr(calc)     ppm   Miss                 Sequence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 - 15            1432.7780     1431.7707    1431.7028       47         0               -.MEGKPSGLPSSTGG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 - 17            1617.8350     1616.8277    1616.8192        5          1               -.MEGKPSGLPSSTGGKG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 - 40          2383.9880     2382.9807    2383.0612      -34         1       K.GVPVVGANPWHSDDGCDGSKSSR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2 - 53          1497.7940     1496.7867    1496.8425      -37         0               R.LMTLTIVIYFQR.I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78 - 97          2233.0920     2232.0847    2232.0369       21         1                R.DADSGMFLSFSEKTQVQTN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0 - 128       2264.0580     2263.0507    2263.0869      -16         1                K.DEVDPDGWVVEIHLRNDQ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52 - 161       1532.8090     1531.8017    1531.7547       31         1                K.FRFWYVCLWR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54 - 163       1514.7680     1513.7607    1513.7289       21         1                R.FWYVCLWRER.S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"/>
          <p:cNvSpPr/>
          <p:nvPr/>
        </p:nvSpPr>
        <p:spPr>
          <a:xfrm>
            <a:off x="684360" y="109440"/>
            <a:ext cx="66308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606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45/5.72  Mr obsd/calcd:72959/72878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" descr=""/>
          <p:cNvPicPr/>
          <p:nvPr/>
        </p:nvPicPr>
        <p:blipFill>
          <a:blip r:embed="rId1"/>
          <a:stretch/>
        </p:blipFill>
        <p:spPr>
          <a:xfrm>
            <a:off x="533520" y="1295280"/>
            <a:ext cx="830556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04560" y="54097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2%</a:t>
            </a:r>
            <a:r>
              <a:rPr b="0" lang="zh-CN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0" y="838080"/>
            <a:ext cx="9144000" cy="510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zh-CN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 MGSREPFLSA IFFFFFLLLF CLGCKCIASE LHLHTTQTAV LKVDASLQH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5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RQIPDTLFGI FFEEINHAGA GGIWAELVSN 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GFEAGGPHT PSNIDPWSII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GDDSSIFVAT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D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TSCFSRNT VAL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MEVLCD NCPAGGVGIY NPGFWGMNIE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DGKTYNLVMY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PETVELT VSLTSSDGSQ NLASSTIPVS GASNWTKLEQ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KLVAKGTNRT SRLQITTTKK GVVWFDQVSL MSADTYKGHG F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TELISMML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DLKP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L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FP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GGCFVEGEWL 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AFRWRESI GPWEERPGHF GDVWHYWTD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GLGYYEFLQL SEDLGAAPIW VFNNGISHND EVDTAAIAPF V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DVLDSLEF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51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GSADSTWG SV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AMGHPE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PFPV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YVAIG NEDCGK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FYR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GNYL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FYNAI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REAYPDIQMI SNCDASSRPL DHPADLYDFH VYTDS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TLFS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MKSAFD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S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5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GP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FVSEY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VW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DAG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G SLLASLAEAA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FLTGLE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SD VVQMASYAPL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5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FVNNNDQTWN PDAIVFNSWQ QYGTPSYWMQ TLF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ESSGAM FHPITITSSY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551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SGSLAASAIT WQDSENSFLR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V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IINFGSDP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SLTISATGL QARVNALGST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601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TVITSSNVM DENSFSNPNK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VVPV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SQLSN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AEQMQVTLA PHSFSSFDLA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651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LAQS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VAEM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-124200" y="1052280"/>
            <a:ext cx="9296280" cy="3801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 ppm   Miss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2 - 112     3258.4650   3257.4577   3257.5266    -21        0  R.GFEAGGPHTPSNIDPWSIIGDDSSIFVATDR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5 - 153     3200.3630   3199.3557   3199.3872    -10        0  R.MEVLCDNCPAGGVGIYNPGFWGMNIEDG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54 - 162    1130.5940   1129.5867   1129.5842       2         0                   K.TYNLVMYV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43 - 255    1546.8030   1545.7957   1545.8258    -19         0                   R.TELISMMLDLKPR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59 - 271    1553.7130   1552.7057   1552.7133      -5         0                   R.FPGGCFVEGEWLR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43 - 352    1164.5860   1163.5787   1163.5822      -3         0                   K.DVLDSLEFA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64 - 375    1280.6340   1279.6267   1279.6383      -9         0                   R.AAMGHPEPFPVK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88 - 395    1060.5450   1059.5377   1059.5501    -12         1                   K.FYRGNYLK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37 - 447    1302.7020   1301.6947   1301.6438     39         1                   K.TLFSMKSAFDR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55 - 464    1227.6140   1226.6067   1226.6084     -1          0                   K.AFVSEYAVWR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70 - 487    1790.9480   1789.9407   1789.9825   -23          0                   R.GSLLASLAEAAFLTGLEK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35 - 570    3848.6870   3847.6797   3847.7999   -31          0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ESSGAMFHPITITSSYSGSLAASAITWQDSENSFLR.V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73 - 593    2160.1190   2159.1117   2159.1586   -22          0                   K.IINFGSDPVSLTISATGLQAR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94 - 620    2797.2650   2796.2577   2796.3236   -24          0  R.VNALGSTATVITSSNVMDENSFSNPN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26 - 655    3206.4900  3205.4827   3205.5714    -28          0  K.SQLSNAAEQMQVTLAPHSFSSFDLALAQSK.L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"/>
          <p:cNvSpPr/>
          <p:nvPr/>
        </p:nvSpPr>
        <p:spPr>
          <a:xfrm>
            <a:off x="684360" y="109440"/>
            <a:ext cx="70117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P_00104462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43/5.42  Mr obsd/calcd:68669/6079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0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8" name="" descr=""/>
          <p:cNvPicPr/>
          <p:nvPr/>
        </p:nvPicPr>
        <p:blipFill>
          <a:blip r:embed="rId1"/>
          <a:stretch/>
        </p:blipFill>
        <p:spPr>
          <a:xfrm>
            <a:off x="685800" y="1295280"/>
            <a:ext cx="8305920" cy="508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456840" y="51051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42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533160" y="1143000"/>
            <a:ext cx="830556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ASSGFSWTL PDHPKLPKGK TVALVVLDGW GEANADKYNC IHVAQTPVM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SLKNGAPERW RLVKAHGTAV GLPSEDDMGN SEVGHNALGA GRIFAQGAK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DLALASG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DGEGFNYIK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CFD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TLH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GLLSDGGVH SRLDQVQLL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ASERGAKR IRVHILTDGR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VLDGSSVGF VETLESDLSQ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KGIDA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SGGGRMYVT MDRYENDWDV VKRGWDAQV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EAPY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QNA VEAVKTLRA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SDQYLP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VIVDESGKS VGPVVDGDA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TFNF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DRM VMLA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LEY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FDKFD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RV PKI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AGMLQ YDGELKLPSH YLVSPPEIE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SGEYLVKN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RTFACSETV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GHVTFFW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N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GYFDET KEEYVEIPSD IGITFNVKP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MKALEIAEKA RDAILSGKFD QVRVNLPNGD MVGHTGDIEA TVVACKAAD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V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ILDAIE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QVGGIYLVTA DHGNAEDMV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NKSGQPLLD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GGIQILT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TLQPVPVAI GGPGLHPGV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RSDIQTPGL ANVAATVMNF HGFEAPADY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PTLIEVVD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2"/>
          <p:cNvSpPr>
            <a:spLocks noGrp="1"/>
          </p:cNvSpPr>
          <p:nvPr>
            <p:ph/>
          </p:nvPr>
        </p:nvSpPr>
        <p:spPr>
          <a:xfrm>
            <a:off x="-360" y="1066680"/>
            <a:ext cx="929628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 ppm   Miss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0 - 120    1318.6390    1317.6317   1317.6241       6          0               K.IYDGEGFNYIK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6 - 142    1731.9270    1730.9197   1730.9428     -13         0               K.GTLHLIGLLSDGGVHS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43 - 151    1069.6600    1068.6527   1068.6543      -1          0               R.LDQVQLLL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71 - 192    2366.1460    2365.1387   2365.1649     -11         0               R.DVLDGSSVGFVETLESDLSQL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0 - 213    1513.7000    1512.6927   1512.7177     -17         1               R.IASGGGRMYVTMDR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7 - 222    2063.9050    2062.8977   2062.9128      -7          1               R.MYVTMDRYENDWDVVK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23 - 236    1589.8000    1588.7927   1588.7998      -4          1               K.RGWDAQVLGEAPYK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24 - 236    1433.7180    1432.7107   1432.6987       8          0               R.GWDAQVLGEAPYK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53 - 269    1864.9220    1863.9147   1863.9254      -6          0               K.ASDQYLPPFVIVDESG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70 - 286    1778.8960    1777.8887   1777.8999      -6          0               K.SVGPVVDGDAVVTFNF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6 - 307    1489.7010    1488.6937   1488.6885       4          1               K.ALEYADFDKFDR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15 - 326    1387.6610    1386.6537   1386.6489       3          0               R.YAGMLQYDGELK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27 - 340    1636.8640    1635.8567   1635.8620      -3          0               K.LPSHYLVSPPEIER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62 - 373    1481.7050    1480.6977   1480.7000      -2          0               K.FGHVTFFWNGNR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54 - 480    2884.4300    2883.4227   2883.4688     -16         0       K.IILDAIEQVGGIYLVTADHGNAEDMVK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92 - 520    2857.4920    2856.4847   2856.5974     -39         0       K.NGGIQILTSHTLQPVPVAIGGPGLHPGVK.F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"/>
          <p:cNvSpPr/>
          <p:nvPr/>
        </p:nvSpPr>
        <p:spPr>
          <a:xfrm>
            <a:off x="684360" y="109440"/>
            <a:ext cx="5792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P_00106387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79/5.43 Mr obsd/calcd:63083/5168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20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" descr=""/>
          <p:cNvPicPr/>
          <p:nvPr/>
        </p:nvPicPr>
        <p:blipFill>
          <a:blip r:embed="rId1"/>
          <a:stretch/>
        </p:blipFill>
        <p:spPr>
          <a:xfrm>
            <a:off x="609480" y="1219320"/>
            <a:ext cx="8305920" cy="4728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228240" y="47239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62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533160" y="837720"/>
            <a:ext cx="8305560" cy="358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VTADVKLE GL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TDKL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QISENEKSGF ISLVSRYLSG EAEQIEWSK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QTPTDEVVVP YDTLSAAPE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NETK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LDK LVVLKLNGGL GTTMGCTGPK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SVIEVRNGFT FLDLIVIQIE SLNK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GCN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LLLMNSFN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DDTQ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VEK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SNSNIEIHT FNQSQYPRIV TEDFLPLPS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KTG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GWY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GHGDVFPS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NSG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DTLL AQG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YVFV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SDNLGAIVD IKILNHLIHN QNEYCMEVT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LADV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G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ISYEGRVQL LEIAQVPDEH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NEF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IE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IFNTNNLW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L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IKRLVE AEALKMEIIP NPKEVDGV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QLETAAGA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FEKAIG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NVPRSRFLPV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TSDLLLVQ SDLYTLVDG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PA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N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NPSIELGP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K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ANFLAR FKSIPSIVEL DTL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SGDVW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GSGVTL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K VTITA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GK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IPDGAVLE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INGPED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-360" y="990720"/>
            <a:ext cx="9296280" cy="5333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ppm   Miss   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4 - 27       1561.7960    1560.7887   1560.7631     16         1                R.AATDKLDQISENE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8 - 36        965.5700      964.5627     964.5342      30         0                K.SGFISLVSR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7 - 49       1539.7990    1538.7917   1538.7252     43         0                R.YLSGEAEQIEWSK.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0 - 75       2845.4430    2844.4357   2844.3917     15         0     K.IQTPTDEVVVPYDTLSAAPEDLNETK.K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0 - 76       2973.5470    2972.5397   2972.4866     18         1     K.IQTPTDEVVVPYDTLSAAPEDLNETKK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6 - 146     2467.1870    2466.1797   2466.1308     20         0                K.YGCNVPLLLMNSFNTHDDTQK.I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51 - 168     2198.0690    2197.0617   2197.0188     20         0                K.YSNSNIEIHTFNQSQYPR.I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69 - 180     1358.8050    1357.7977   1357.7493     36         0                R.IVTEDFLPLPS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6 - 205     2144.0300    2143.0227   2142.9759     22         0                K.DGWYPPGHGDVFPSLNNSGK.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15 - 232    1967.0550    1966.0477   1966.0047     22         0                K.EYVFVANSDNLGAIVDIK.I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33 - 251    2353.1910    2352.1837   2352.1354     21         0                K.ILNHLIHNQNEYCMEVTPK.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58 - 267    1052.5740    1051.5667   1051.5298     35         0                K.GGTLISYEGR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68 - 285    2108.1410    2107.1337   2107.0950     18         0                R.VQLLEIAQVPDEHVNEF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0 - 303    1750.9920    1749.9847   1749.9566     16         1                K.FKIFNTNNLWVNL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2 - 303    1475.8430    1474.8357   1474.7932     29         0                K.IFNTNNLWVNLK.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30 - 342    1312.8060    1311.7987   1311.7510     36         0                K.VLQLETAAGAAIR.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62 - 383    2438.3350    2437.3277   2437.3105      7          0                K.ATSDLLLVQSDLYTLVDGFVIR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88 - 402    1629.8470    1628.8397   1628.8046     22         0                R.TNPSNPSIELGPEFK.K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88 - 403    1757.9430    1756.9357   1756.8995     21         1                R.TNPSNPSIELGPEFK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25 - 438    1451.8040    1450.7967   1450.7457     35         0                K.VSGDVWFGSGVTL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47 - 461    1569.8790    1568.8717   1568.8410     20         1                K.SGKLEIPDGAVLEN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50 - 461    1297.7490    1296.7417   1296.6925     38         0                K.LEIPDGAVLENK.D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"/>
          <p:cNvSpPr/>
          <p:nvPr/>
        </p:nvSpPr>
        <p:spPr>
          <a:xfrm>
            <a:off x="684360" y="109440"/>
            <a:ext cx="70880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BAB557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17/5.21  Mr obsd/calcd:95060/8712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6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609480" y="1295280"/>
            <a:ext cx="830592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"/>
          <p:cNvSpPr/>
          <p:nvPr/>
        </p:nvSpPr>
        <p:spPr>
          <a:xfrm>
            <a:off x="684360" y="109440"/>
            <a:ext cx="70880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Q4297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64/5.41 Mr obsd/calcd:59522/4797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25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0" name="" descr=""/>
          <p:cNvPicPr/>
          <p:nvPr/>
        </p:nvPicPr>
        <p:blipFill>
          <a:blip r:embed="rId1"/>
          <a:stretch/>
        </p:blipFill>
        <p:spPr>
          <a:xfrm>
            <a:off x="533520" y="1371600"/>
            <a:ext cx="830556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304560" y="54097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73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533160" y="837720"/>
            <a:ext cx="8305560" cy="4343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MAATIVSV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QIFDSRGNP TVEVDVCCSD GTFARAAVP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ASTGVYEA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   EL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GGSDYL GKGVS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VD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NSVIAPALI GKDPTSQAEL DNFMVQQLD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KNEWGWCKQ KLGANAILA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LAIC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GAI I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IPLYQH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NLAGN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QL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PVPAFNVIN GGSHAGN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QEFMILPT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SF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AM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VEVYHNL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IK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YGQD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NVGDEGGFA PNIQENKEG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LL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AIEKA GYTG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VIGM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VAASEFYND KDKTYDLNFK EENNDGSQK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I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SGDSLKNVYK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FVSEYPIV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EDPFDQDDW EHYAKMTAE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EQVQIVGD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LVTNPT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A KAIQEKSCN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LL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NQIGS VTESIEAV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 SK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WGVMT SHRSGETEDT FIADLAVGL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GQI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GAPC RSERLAKYNQ LL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EEELGA AAVYAGAKFR APVEPY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2"/>
          <p:cNvSpPr>
            <a:spLocks noGrp="1"/>
          </p:cNvSpPr>
          <p:nvPr>
            <p:ph/>
          </p:nvPr>
        </p:nvSpPr>
        <p:spPr>
          <a:xfrm>
            <a:off x="-360" y="990720"/>
            <a:ext cx="9296280" cy="586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 ppm   Miss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 - 17       992.5550       991.5477     991.5199       28        1                  K.ARQIFDS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 - 35      1983.8730     1982.8657   1982.8463      10        0                  R.GNPTVEVDVCCSDGTFA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6 - 53      1790.9520     1789.9447   1789.9210      13        0                  R.AAVPSGASTGVYEALELR.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7 - 82      1580.9360     1579.9287   1579.8933      22        0                  K.AVDNVNSVIAPALIG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7 - 102    3798.8970     3797.8897   3797.9146      -7         1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AVDNVNSVIAPALIGKDPTSQAELDNFMVQQLDGTK.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3 - 109    3197.5070     3196.4997   3196.4230      24        1  K.DPTSQAELDNFMVQQLDGTKNEWGWCK.Q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0 - 126   1770.0330     1769.0257   1769.0233       1         1                  K.QKLGANAILAVSLAIC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2 - 126   1513.9100     1512.9027   1512.8698      22        0                  K.LGANAILAVSLAIC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3 - 147   1679.9880     1678.9807   1678.9518      17        1                  K.KIPLYQHIANLAGNK.Q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4 - 147   1551.8910     1550.8837   1550.8569      17        0                  K.IPLYQHIANLAGNK.Q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69 - 185   1854.9760     1853.9687   1853.9419      14        0                  K.LAMQEFMILPTGAASFK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90 - 199   1189.6470     1188.6397   1188.5961      37        0                  K.MGVEVYHNL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5 - 227   2452.2250     2451.2177   2451.1302      36        1                  K.KYGQDATNVGDEGGFAPNIQENK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6 - 227   2324.0730     2323.0657   2323.0353      13        0                  K.YGQDATNVGDEGGFAPNIQENK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6 - 234   3106.5410     3105.5337   3105.4891      14        1  K.YGQDATNVGDEGGFAPNIQENKEGLELL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46 - 263   2000.9830     1999.9757   1999.9561      10        1                  K.VVIGMDVAASEFYNDKDK.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64 - 279   1901.8940     1900.8867   1900.8439      23        1                  K.TYDLNFKEENNDGSQK.I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1 - 315   3016.4170     3015.4097   3015.3450      21        0   K.SFVSEYPIVSIEDPFDQDDWEHYAK.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16 - 338   2499.2930     2498.2857   2498.2687       7         0                  K.MTAEIGEQVQIVGDDLLVTNPTR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55 - 369   1573.8720     1572.8647   1572.8359      18        0                  K.VNQIGSVTESIEAVK.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74 - 383   1101.5510     1100.5437   1100.5186       23       0                  R.AGWGVMTSHR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84 - 405   2236.1590     2235.1517   2235.1271       11       0                  R.SGETEDTFIADLAVGLATGQIK.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24 - 438   1491.8030     1490.7957   1490.7616       23       0                  R.IEEELGAAAVYAGAK.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39 - 446    978.5430       977.5357     977.4971        40       1                  K.FRAPVEPY.-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"/>
          <p:cNvSpPr/>
          <p:nvPr/>
        </p:nvSpPr>
        <p:spPr>
          <a:xfrm>
            <a:off x="684360" y="109440"/>
            <a:ext cx="66308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P_00106422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59/5.5  Mr obsd/calcd:58954/47914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22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6" name="" descr=""/>
          <p:cNvPicPr/>
          <p:nvPr/>
        </p:nvPicPr>
        <p:blipFill>
          <a:blip r:embed="rId1"/>
          <a:stretch/>
        </p:blipFill>
        <p:spPr>
          <a:xfrm>
            <a:off x="609480" y="1371600"/>
            <a:ext cx="830592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228240" y="47239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69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/>
          </p:nvPr>
        </p:nvSpPr>
        <p:spPr>
          <a:xfrm>
            <a:off x="533160" y="837720"/>
            <a:ext cx="8305560" cy="358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AATIVSV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QIFDSRGNP TVEVDVCCSD GTFARAAVPS GASTGVYEA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   EL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GGSDYL GKGVS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VD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NSVIAPALI G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TSQAEL DNFMVQQLD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KNEWGWC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Q KLGANAILA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LAIC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GAI I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IPLYQH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NLAGN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QL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PVPAFNVIN GGSHAGN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QAFMILPT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SF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AM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 GVEVYHNL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IK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YGQDA TNVGDEGGFA PNIQENKEG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LL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AIEKA GYTG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VIGM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VAASEFYND KDKTYDLNF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ENNDGSQ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 SGDSLKNVYK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FVSEYPIV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EDPFDQDDW EHYAKMTAEI GEQVQIVGD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LVTNPT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A KAIQE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CN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LLKVNQIG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TESIEAV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 SK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WGVM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HRSGETEDT FIADLAVGL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 TGQI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GAPC RSERLAKYNQ LL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EEELGA AAVYAGAKFR APVEPY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-360" y="990720"/>
            <a:ext cx="9296280" cy="5867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 ppm   Miss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 - 17         992.5410      991.5337     991.5199      14         1                  K.ARQIFDS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 - 35        1983.8690    1982.8617   1982.8463      8          0                  R.GNPTVEVDVCCSDGTFA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6 - 53        1790.9430    1789.9357   1789.9210      8          0                  R.AAVPSGASTGVYEALEL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7 - 82        1580.9300    1579.9227   1579.8933     19         0                  K.AVDNVNSVIAPALIG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0 - 126      1770.0260    1769.0187   1769.0233     -3          1                  K.QKLGANAILAVSLAIC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2 - 126      1513.9030    1512.8957   1512.8698     17         0                  K.LGANAILAVSLAIC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3 - 147      1679.9730    1678.9657   1678.9518      8          1                  K.KIPLYQHIANLAGNK.Q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4 - 147      1551.8870    1550.8797   1550.8569     15         0                  K.IPLYQHIANLAGNK.Q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69 - 185      1797.0310    1796.0237   1795.9365     49         0                  K.LAMQAFMILPTGAASFK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90 - 199      1189.6360    1188.6287   1188.5961     27         0                  K.MGVEVYHNLK.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5 - 227      2452.1920    2451.1847   2451.1302     22         1                  K.KYGQDATNVGDEGGFAPNIQENK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6 - 227      2324.0560    2323.0487   2323.0353      6          0                  K.YGQDATNVGDEGGFAPNIQENK.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6 - 234      3106.5530    3105.5457   3105.4891     18         1   K.YGQDATNVGDEGGFAPNIQENKEGLELL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46 - 263      2000.9730    1999.9657   1999.9561      5          1                  K.VVIGMDVAASEFYNDKD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64 - 279      1901.8780    1900.8707   1900.8439     14         1                  K.TYDLNFKEENNDGSQK.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1 - 315      3016.4960    3015.4887   3015.3450     48         0   K.SFVSEYPIVSIEDPFDQDDWEHYAK.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16 - 338      2499.2850    2498.2777   2498.2687      4          0                  K.MTAEIGEQVQIVGDDLLVTNPTR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47 - 354       918.5370      917.5297     917.5004      32         0                  K.SCNALLL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55 - 369     1573.8660     1572.8587   1572.8359     15         0                  K.VNQIGSVTESIEAVK.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74 - 383     1101.5470     1100.5397   1100.5186     19         0                  R.AGWGVMTSHR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84 - 405     2236.1370     2235.1297   2235.1271      1          0                  R.SGETEDTFIADLAVGLATGQI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24 - 438     1491.7960     1490.7887   1490.7616     18         0                  R.IEEELGAAAVYAGAK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39 - 446       978.5330       977.5257     977.4971      29        1                  K.FRAPVEPY.-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"/>
          <p:cNvSpPr/>
          <p:nvPr/>
        </p:nvSpPr>
        <p:spPr>
          <a:xfrm>
            <a:off x="684360" y="109440"/>
            <a:ext cx="62499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406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68/6.32   Mr obsd/calcd:48872/5342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6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" descr=""/>
          <p:cNvPicPr/>
          <p:nvPr/>
        </p:nvPicPr>
        <p:blipFill>
          <a:blip r:embed="rId1"/>
          <a:stretch/>
        </p:blipFill>
        <p:spPr>
          <a:xfrm>
            <a:off x="609480" y="121932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1%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04920" y="2205000"/>
            <a:ext cx="8610480" cy="2527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DAGSKSSSS GPLHLVIFPW LAFGHLLPYL ELAE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ASR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HRVSFVSTP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NI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PPVRP AAAARVDLVA LPLP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VDGL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DGAECTNDV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G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DLLWK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FDALAAPFAE FLGAACRDAG DGERRPDWII ADTFHHWAPL VALQHKVPC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MLLPSASMMV GWAIRSSEPA GASMFEVLGA VEER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MDMPC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YEWEQ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AL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ADGASGMSI MK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CSLAME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CTVAAM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CP EWEPEAFQQV AAGLKKKNK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IPLGLVPPS PDGGRRRAGS MSTDNSTMQW LDAQPAKSVV YVALGSEVP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RLEQVHELAL GLELAGTRFL WALRKHAGVD AADDVLPPGY RERTNGHGH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MGWVPQIAI LAHAAVGAFL THCGRNSLVE GLMFGNPLIM LPIFTDQGP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RLMEGNKVG LQVR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RDDTD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SFDRHGVAAA VRAVMVEEE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RRVFVANAL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1 </a:t>
            </a:r>
            <a:r>
              <a:rPr b="1" lang="en-US" sz="1600" spc="-1" strike="noStrike">
                <a:solidFill>
                  <a:srgbClr val="ff3300"/>
                </a:solidFill>
                <a:latin typeface="Arial"/>
              </a:rPr>
              <a:t>MQKIVTD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L HERYIDDFIQ QLVSHVADSS CNIATPVPSS S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2"/>
          <p:cNvSpPr>
            <a:spLocks noGrp="1"/>
          </p:cNvSpPr>
          <p:nvPr>
            <p:ph/>
          </p:nvPr>
        </p:nvSpPr>
        <p:spPr>
          <a:xfrm>
            <a:off x="0" y="1600200"/>
            <a:ext cx="914400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- End    Observed    Mr(expt)     Mr(calc)   Delta     Miss               Sequence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6 - 42            782.3386         781.3313      781.4307    -0.0994    1        R.VASRGHR.V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3 - 54            1346.7360      1345.7287    1345.7466   -0.0179    1        R.VSFVSTPRNIAR.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76 - 93            1773.8870      1772.8797    1772.7886    0.0911    0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R.VDGLPDGAECTNDVPSGK.F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86 - 196         1475.7788      1474.7715    1474.5567    0.2148    0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MDMPCYEWEQK.A Oxidation (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14 - 220         825.4222        824.4149      824.3520     0.0629    0 R.CSLAMER.C Oxidation (M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14 - 227        1541.7787      1540.7714    1540.6982    0.0732    1 R.CSLAMERCTVAAMR.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15 - 424        1183.6003      1182.5930    1182.4901    0.1029    1 R.RDDTDGSFDR.H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16 - 432        1788.9076      1787.9003    1787.8186    0.0817    1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R.DDTDGSFDRHGVAAAVR.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33 - 442         1219.6051      1218.5978    1218.6026   -0.0048   1 R.AVMVEEETRR.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42 - 450        1045.5880      1044.5807     1044.6192   -0.0385   1 R.RVFVANALR.M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43 - 453        1276.6858      1275.6785     1275.7121    -0.0336  1 R.VFVANALRMQK.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43 - 453        1276.6858      1275.6785     1275.7121    -0.0336  1 R.VFVANALRMQK.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451 - 458         978.5208         977.5135      977.5215     -0.0080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  R.MQKIVTDK.E Oxidation (M)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"/>
          <p:cNvSpPr/>
          <p:nvPr/>
        </p:nvSpPr>
        <p:spPr>
          <a:xfrm>
            <a:off x="684360" y="109440"/>
            <a:ext cx="67071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P_00106063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49/5.93  Mr obsd/calcd:47913/4704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5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0" name="" descr=""/>
          <p:cNvPicPr/>
          <p:nvPr/>
        </p:nvPicPr>
        <p:blipFill>
          <a:blip r:embed="rId1"/>
          <a:stretch/>
        </p:blipFill>
        <p:spPr>
          <a:xfrm>
            <a:off x="533520" y="1219320"/>
            <a:ext cx="8305560" cy="50846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304560" y="53337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6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/>
          </p:nvPr>
        </p:nvSpPr>
        <p:spPr>
          <a:xfrm>
            <a:off x="609480" y="533160"/>
            <a:ext cx="8305920" cy="5638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AASSSPRRL GFLAALVFAV SVSASVSSVS GGSGPITTNG GNYTRVCDP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RFAAAGLDMA GFPYCDASLP YADRVRDLVG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TLEEKVA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GD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GGAP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GLPRYLWWG EALHGVSDVG PGGTWFGDAV PGATSFPLVI NSAASFNET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WRAIGGVVST EIRAMYNLGH AELTYWSPNI NVVRDPRWGR ASETPGEDP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VGRYAVNFV RGMQDIDGAT TAASAAAATD AFSRPIKVSS CCKHYAAYD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AWNGTDRLT FDARVQE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M VETFERPFEM C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GDASCV MCSYNRING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PACADARLLT ETVR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WQLH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YIVSDCDS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MVRDA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W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YTGVEATA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MKAGLDLDC GMFWEGVHDF FTTYGVDAV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QGKL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SAV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ALTNLYLT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GFFDGIP ELESLGAADV CTEEHKELAA DAARQGMVLL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DAALLPL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E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NSVALF GQLQHINATD VMLGDYRGKP CRVVTPYDGV RKVVSSTSVH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CDKGSCDTA AAAAKTVDAT IVVAGLNMSV ERESNDREDL LLPWSQASW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NAVAEASPSP IVLVIMSAGG VDVSFAQDNP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GAVVWAG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GEEGGTAI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VLFG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YNPG GRLPLTWYKN EYVS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PMT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ALRPDAEHG YPG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YKFY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ADVLYPFGH GLSYTNFTYA SATAAAPVTV KVGAWEYCKQ LTY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VSS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7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ACPAVNVAS HACQEEVSF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TVANTGG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 GTHVVPMYTA PPAEVDGAP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7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QLVAFRRVR VAAGAAVEVA FALNVC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FA IVEETAYTV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SGVS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LV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8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DALSLSFPV QIDLQAA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228240" y="47239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62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2"/>
          <p:cNvSpPr>
            <a:spLocks noGrp="1"/>
          </p:cNvSpPr>
          <p:nvPr>
            <p:ph/>
          </p:nvPr>
        </p:nvSpPr>
        <p:spPr>
          <a:xfrm>
            <a:off x="533160" y="837720"/>
            <a:ext cx="8305560" cy="358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EAPRLRLPF LLLVALVVSP PAVAAAASRM RIEPLPTAAL RRLYDTSNY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KLQLNNGLAL TPQMGWNSWN FFACNINETV I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TADALVS TGLADLGYNY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 VNIDDCWSN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GK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QLL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P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FPSGIK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LADYVHG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 L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GIYSDA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FTCQVRPGS LHHEKDDAAI FASWGVDYLK YDNCYNLGI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KDRYPPM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LNSTG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QI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SLCEWGQD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ALWAG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GN SW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TDDIQ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W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MTDIA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NN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WASYA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GGWNDPDML EVGNGGMTFA EYRAHFSIWA LMKAPLLIG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 D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MT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TM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ILSNKEVIQ VNQDPLGVQ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ILGQG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G CQEVWAGP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NRLAVVLW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EESANIIV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PSVGLDG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PYS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LWK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ETLSENVV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FGAQVDVHD C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YIFTPAV TVAS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PlaceHolder 2"/>
          <p:cNvSpPr>
            <a:spLocks noGrp="1"/>
          </p:cNvSpPr>
          <p:nvPr>
            <p:ph/>
          </p:nvPr>
        </p:nvSpPr>
        <p:spPr>
          <a:xfrm>
            <a:off x="-360" y="1066680"/>
            <a:ext cx="9296280" cy="4191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ppm  Miss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3 - 111     3189.5510    3188.5437   3188.4608     26        0 R.DTADALVSTGLADLGYNYVNIDDCWSNVK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6 - 123     925.5230      924.5157     924.4916      26        0                   K.DQLLPDP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1 - 139    1017.5210    1016.5137   1016.4927     21        0                   K.DLADYVHG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43 - 165    2585.2960    2584.2887   2584.2856      1         0                   K.LGIYSDAGIFTCQVRPGSLHHE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66 - 180    1670.8260    1669.8187   1669.7988     12        0                   K.DDAAIFASWGVDYLK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1 - 192    1484.7650    1483.7577   1483.7129     30        0                   K.YDNCYNLGIKP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93 - 199     934.4810      933.4737     933.4491      26        1                   K.DRYPPM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8 - 227    2384.1370    2383.1297   2383.0943     15        0                   R.QIFYSLCEWGQDDPALWAG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34 - 243    1222.6070    1221.5997   1221.5514     40        0                   R.TTDDIQDTW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55 - 283    3148.3680    3147.3607   3147.3491      4         0 K.WASYAGPGGWNDPDMLEVGNGGMTFAEY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84 - 293    1203.6610    1202.6537   1202.6270     22        0                   R.AHFSIWALMK.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4 - 303    1113.6250    1112.6177   1112.6012     15        0                   K.APLLIGCDVR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08 - 331    2697.3520    2696.3447   2696.3803    -13        1                   K.ETMEILSNKEVIQVNQDPLGVQGR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17 - 331    1651.8980    1650.8907   1650.8689     13        0                   K.EVIQVNQDPLGVQGR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39 - 353    1644.7870    1643.7797   1643.7474     20        0                   K.NGCQEVWAGPLSGNR.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54 - 361     970.5930      969.5857     969.5760      10        0                   R.LAVVLWNR.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72 - 386    1533.8140    1532.8067   1532.7835     15        0                   K.LPSVGLDGSSPYSV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91 - 412    2442.1390     2441.1317  2441.1282      1         0                   K.HETLSENVVGTFGAQVDVHDCK.M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"/>
          <p:cNvSpPr/>
          <p:nvPr/>
        </p:nvSpPr>
        <p:spPr>
          <a:xfrm>
            <a:off x="684360" y="109440"/>
            <a:ext cx="6783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P_00106063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70/5.93  Mr obsd/calcd:47112/4704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3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6" name="" descr=""/>
          <p:cNvPicPr/>
          <p:nvPr/>
        </p:nvPicPr>
        <p:blipFill>
          <a:blip r:embed="rId1"/>
          <a:stretch/>
        </p:blipFill>
        <p:spPr>
          <a:xfrm>
            <a:off x="685800" y="1219320"/>
            <a:ext cx="8291520" cy="4743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228240" y="47239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54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PlaceHolder 2"/>
          <p:cNvSpPr>
            <a:spLocks noGrp="1"/>
          </p:cNvSpPr>
          <p:nvPr>
            <p:ph/>
          </p:nvPr>
        </p:nvSpPr>
        <p:spPr>
          <a:xfrm>
            <a:off x="533160" y="837720"/>
            <a:ext cx="8305560" cy="358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MEAPRLRLPF LLLVALVVSP PAVAAAASRM RIEPLPTAAL RRLYDTSNY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KLQLNNGLAL TPQMGWNSWN FFACNINETV I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TADALV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GLADLGYN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NIDDCWSN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GKKDQLLP DPKTFPSGIK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LADYVHG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 L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GIYSDA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FTCQVRPGS LHHEKDDAAI FASWGVDYLK YDNCYNLGI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RYPPMR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LNSTG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QIF YSLCEWGQD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ALWAG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GN SWRTTDDIQD TWKSMTDIA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NN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WASYA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GGWNDPDML EVGNGGMTFA EYRAHFSIWA LMKAPLLIGC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MTKETM EILSN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VIQ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NQDPLGVQG 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ILGQG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CQEVWAGPL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NRLAVVLWN 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EESANIIV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PSVGLDG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PYS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LWK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ETLSENVV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FGAQVDVH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C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YIFTPAV TVAS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/>
          </p:nvPr>
        </p:nvSpPr>
        <p:spPr>
          <a:xfrm>
            <a:off x="-360" y="990360"/>
            <a:ext cx="9296280" cy="373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 ppm  Miss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3 - 111     3189.4660    3188.4587   3188.4608     -1         0   R.DTADALVSTGLADLGYNYVNIDDCWSNVK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1 - 139     1017.5420    1016.5347   1016.4927     41        0                    K.DLADYVHG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43 - 165     2585.3010    2584.2937   2584.2856      3         0                    K.LGIYSDAGIFTCQVRPGSLHHE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66 - 180     1670.8590    1669.8517   1669.7988     32        0                    K.DDAAIFASWGVDYLK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1 - 192     1484.7870    1483.7797   1483.7129     45        0                    K.YDNCYNLGIKP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8 - 227     2384.0970    2383.0897   2383.0943     -2         0                    R.QIFYSLCEWGQDDPALWAG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55 - 283     3148.3750    3147.3677   3147.3491      6         0  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WASYAGPGGWNDPDMLEVGNGGMTFAEYR.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84 - 293     1203.6790    1202.6717   1202.6270     37        0                    R.AHFSIWALM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4 - 303     1113.6580    1112.6507   1112.6012     45        0                    K.APLLIGCDVR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17 - 331     1651.9340    1650.9267   1650.8689     35        0                    K.EVIQVNQDPLGVQGR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39 - 353     1644.8070    1643.7997   1643.7474     32        0                    K.NGCQEVWAGPLSGNR.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54 - 361      970.6270      969.6197     969.5760      45        0                    R.LAVVLWNR.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72 - 386     1533.8550    1532.8477   1532.7835     42        0                    K.LPSVGLDGSSPYSV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91 - 412     2442.1670    2441.1597   2441.1282     13        0                    K.HETLSENVVGTFGAQVDVHDCK.M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"/>
          <p:cNvSpPr/>
          <p:nvPr/>
        </p:nvSpPr>
        <p:spPr>
          <a:xfrm>
            <a:off x="684360" y="109440"/>
            <a:ext cx="62499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CAA7723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80/5.83 Mr obsd/calcd:45730/4137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0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" descr=""/>
          <p:cNvPicPr/>
          <p:nvPr/>
        </p:nvPicPr>
        <p:blipFill>
          <a:blip r:embed="rId1"/>
          <a:stretch/>
        </p:blipFill>
        <p:spPr>
          <a:xfrm>
            <a:off x="533520" y="1371600"/>
            <a:ext cx="830556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228240" y="47239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55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2"/>
          <p:cNvSpPr>
            <a:spLocks noGrp="1"/>
          </p:cNvSpPr>
          <p:nvPr>
            <p:ph/>
          </p:nvPr>
        </p:nvSpPr>
        <p:spPr>
          <a:xfrm>
            <a:off x="533160" y="837720"/>
            <a:ext cx="8305560" cy="358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GTVTVPSP SVPSTPLLKD ELDIVIPTIR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LDFLEMWR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FQPYHLII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QDGDPT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IR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PEGFDYELY N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DINRILG PKASCISFKD SACRCFGYM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SKK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VFTID DDCFVA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S G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INALEQH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KNLLSPSTP FFFNTLYDP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GADFVRGY PFSLREGA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 AVSHGLWLNI PDYDAPTQM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P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RNSRY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AVMTVP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FPMCGMNLA FDRDLIGPAM YFGLMGDGQP IGRYDDMWA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WCMKVICDHL SLGVKTGLP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WHS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SNPF VNLKKEY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WQEDIIPF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QNATIP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CD TVQ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CYLSL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Q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KLGKI DPYFVKLADA MVTWIEAWD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NPSTAAVEN GKAK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PlaceHolder 2"/>
          <p:cNvSpPr>
            <a:spLocks noGrp="1"/>
          </p:cNvSpPr>
          <p:nvPr>
            <p:ph/>
          </p:nvPr>
        </p:nvSpPr>
        <p:spPr>
          <a:xfrm>
            <a:off x="-360" y="990720"/>
            <a:ext cx="9296280" cy="3200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 ppm  Miss               Sequence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1 - 57       3319.6470   3318.6397   3318.6536     -4         0        R.NLDFLEMWRPFFQPYHLIIVQDGDPT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1 - 72       1501.7240   1500.7167   1500.6885     19        0                    R.VPEGFDYELYNR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5 - 117     1592.7390   1591.7317   1591.7229      6         0                    K.YVFTIDDDCFVA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3 - 132      1180.6290   1179.6217   1179.6248     -3         0                    K.DINALEQHIK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3 - 151      2292.1400   2291.1327   2291.1263      3         0                    K.NLLSPSTPFFFNTLYDPYR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70 - 193      2709.3960   2708.3887   2708.3745      5         0       K.TAVSHGLWLNIPDYDAPTQMVKPR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9 - 223      1729.7890   1728.7817   1728.7786      2         0                    K.GTLFPMCGMNLAFDR.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24 - 243     2108.0240   2107.0167   2107.0231      -3         0                     R.DLIGPAMYFGLMGDGQPIGR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44 - 254     1462.5760   1461.5687   1461.5516      12        0                    R.YDDMWAGWCM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55 - 265     1240.6850   1239.6777   1239.6646      11        0                    K.VICDHLSLGV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66 - 275     1201.6580   1200.6507   1200.6291      18        0                    K.TGLPYIWHS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89 - 307     2264.1640  2263.1567   2263.1677       -5         0                    K.GIFWQEDIIPFFQNATIPK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15 - 324     1238.6450  1237.6377   1237.6125       20        0                    K.CYLSLAEQVR.E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"/>
          <p:cNvSpPr/>
          <p:nvPr/>
        </p:nvSpPr>
        <p:spPr>
          <a:xfrm>
            <a:off x="684360" y="109440"/>
            <a:ext cx="6783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BAA7778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15/7.02   Mr obsd/calcd:33882/3560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8" name="" descr=""/>
          <p:cNvPicPr/>
          <p:nvPr/>
        </p:nvPicPr>
        <p:blipFill>
          <a:blip r:embed="rId1"/>
          <a:stretch/>
        </p:blipFill>
        <p:spPr>
          <a:xfrm>
            <a:off x="609480" y="1219320"/>
            <a:ext cx="8305920" cy="4728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44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2"/>
          <p:cNvSpPr>
            <a:spLocks noGrp="1"/>
          </p:cNvSpPr>
          <p:nvPr>
            <p:ph/>
          </p:nvPr>
        </p:nvSpPr>
        <p:spPr>
          <a:xfrm>
            <a:off x="533160" y="1218960"/>
            <a:ext cx="8305560" cy="373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KMGFAPMLSV AVLLGTLAAF PAAVHSIGVC YGVVANNLPG PSEVVQLYR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KGIDSMRIYF ADAAALNALS GSNIGLIMDV GNGNLSSLAS SPSAAAGWV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NIQAYPGVS FRYIAVGNEV QGSDTANILP AMRNVNSAL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GLGNI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SV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DAFA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FPPSSGRFR DDYMTPIARF LATTGAPLLA NVYPYFAYK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QESGQ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IM LNYATFQPGT TVVDNGNRLT YTCLFDAMVD SIYAALE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PSVSVVVSE SGWPSAGGKV GASVNNAQT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QGLINH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 GTPKKRRAL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YIFAMFDEN GKPGDEIE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GLFNPN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P SYSIS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-360" y="1218960"/>
            <a:ext cx="9296280" cy="297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 ppm  Miss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2 - 94       1475.8190    1474.8117   1474.7449      45        1              R.MTLEEKVANLGD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69 - 283     1959.9300    1958.9227   1958.8689      27        0              R.DMVETFERPFEMCI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16 - 331     1949.9360    1948.9287   1948.8738      28        0              R.DWQLHGYIVSDCDSVR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39 - 353     1568.8360    1567.8287   1567.7704      37        0              K.WLGYTGVEATAAAM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54 - 380     3078.3910    3077.3837   3077.3688       5         0  K.AGLDLDCGMFWEGVHDFFTTYGVDAVR.Q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86 - 402     1924.0180    1923.0107   1922.9771      17        0              K.ESAVDNALTNLYLTLM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42 - 453     1267.7150    1266.7077   1266.6819      20        0              K.NDAALLPLSPE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82 - 606     2477.2920    2476.2847   2476.2638       8         0              K.IGAVVWAGYPGEEGGTAIADVLFGK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26 - 644     2099.0620    2098.0547   2098.0088      22        0              K.IPMTSMALRPDAEHGYPGR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95 - 729     3497.5650    3496.5577   3496.6464     -25        0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AGVSSPPACPAVNVASHACQEEVSFAVTVANTGGR.D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778 - 796     1996.0750    1995.0677   1995.0313      18        0              K.AFAIVEETAYTVVPSGVSR.V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2"/>
          <p:cNvSpPr>
            <a:spLocks noGrp="1"/>
          </p:cNvSpPr>
          <p:nvPr>
            <p:ph/>
          </p:nvPr>
        </p:nvSpPr>
        <p:spPr>
          <a:xfrm>
            <a:off x="0" y="1143000"/>
            <a:ext cx="9144000" cy="28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 Mr(expt)    Mr(calc)     ppm   Miss    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01 - 112   1366.6930   1365.6857 1365.6677    13     0              R.DNIQAYPGVSFR.Y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13 - 133   2219.1290   2218.1217  2218.1052    7      0 R.YIAVGNEVQGSDTANILPAMR.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34 - 148   1440.7930   1439.7857  1439.8096  -17     0              R.NVNSALVAAGLGNIK.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55 - 168   1514.7250   1513.7177  1513.6838   22     0              R.FDAFADTFPPSSGR.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69 - 179   1384.6890   1383.6817  1383.6605   15     1              R.FRDDYMTPIAR.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80 - 207    3107.5180   3106.5107  3106.5287   -6     1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R.FLATTGAPLLANVYPYFAYKDDQESGQK.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49 - 269    1958.9950   1957.9877  1957.9745    7     0  K.AGTPSVSVVVSESGWPSAGGK.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70 - 289    2155.1010   2154.0937  2154.0930    0     0  K.VGASVNNAQTYNQGLINHVR.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20 - 328    1073.5550   1072.5477  1072.5454    2     0              K.HFGLFNPNK.S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"/>
          <p:cNvSpPr/>
          <p:nvPr/>
        </p:nvSpPr>
        <p:spPr>
          <a:xfrm>
            <a:off x="684360" y="109440"/>
            <a:ext cx="64022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64/7.02   Mr obsd/calcd:33110/3560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4" name="" descr=""/>
          <p:cNvPicPr/>
          <p:nvPr/>
        </p:nvPicPr>
        <p:blipFill>
          <a:blip r:embed="rId1"/>
          <a:stretch/>
        </p:blipFill>
        <p:spPr>
          <a:xfrm>
            <a:off x="609480" y="1295280"/>
            <a:ext cx="830592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5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53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PlaceHolder 2"/>
          <p:cNvSpPr>
            <a:spLocks noGrp="1"/>
          </p:cNvSpPr>
          <p:nvPr>
            <p:ph/>
          </p:nvPr>
        </p:nvSpPr>
        <p:spPr>
          <a:xfrm>
            <a:off x="533160" y="1219320"/>
            <a:ext cx="8305560" cy="31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 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MGFAPMLSV AVLLGTLAAF PAAVHSIGVC YGVVANNLPG PSEVVQLYR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KGIDSMRIYF ADAAALNALS GSNIGLIMDV GNGNLSSLAS SPSAAAGWV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NIQAYPGVS FRYIAVGNEV QGSDTANILP AMRNVNSAL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GLGNI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SV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DAFA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FPPSSGRFR DDYMTPIARF LATTGAPLLA NVYPYFAYK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 DQESGQKNIM LNYATFQPG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VVDNGN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T YTCLFDAMVD SIYAALE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PSVSVVVSE SGWPSAGGKV GASVNNAQT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QGLINH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 GTPKKRRAL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YIFAMFDEN GKPGDEIE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 FGLFNPNKSP SYSISF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/>
          </p:nvPr>
        </p:nvSpPr>
        <p:spPr>
          <a:xfrm>
            <a:off x="-360" y="1219320"/>
            <a:ext cx="9296280" cy="350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- End  Observed  Mr(expt)   Mr(calc)    ppm   Miss                 Sequence</a:t>
            </a:r>
            <a:r>
              <a:rPr b="0" lang="zh-CN" sz="2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1 - 112       1366.6870       1365.6797      1365.6677         9            0                    R.DNIQAYPGVSFR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3 - 133       2219.0880       2218.0807      2218.1052       -11           0 R.YIAVGNEVQGSDTANILPAMR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3 - 148       3640.8200       3639.8127      3639.9042       -25           1 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R.YIAVGNEVQGSDTANILPAMRNVNSALVAAGLGNIK.V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4 - 148       1440.8180       1439.8107      1439.8096         1             0                   R.NVNSALVAAGLGNI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55 - 168       1514.7010       1513.6937      1513.6838         7             0                   R.FDAFADTFPPSSGR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69 - 179       1384.6850       1383.6777      1383.6605        12            1                   R.FRDDYMTPIAR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0 - 207       3107.5000       3106.4927      3106.5287       -12            1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FLATTGAPLLANVYPYFAYKDDQESGQK.N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8 - 228       2325.0840       2324.0767      2324.1219       -19            0 K.NIMLNYATFQPGTTVVDNGN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49 - 269       1958.9620       1957.9547      1957.9745       -10            0 K.AGTPSVSVVVSESGWPSAGG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70 - 289       2155.0610       2154.0537      2154.0930       -18            0 K.VGASVNNAQTYNQGLINHV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20 - 328       1073.5760       1072.5687      1072.5454         22           0                   K.HFGLFNPN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20 - 336       1941.9490       1940.9417      1940.9421         -0            1                   K.HFGLFNPNKSPSYSISF.-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9" name=""/>
          <p:cNvSpPr/>
          <p:nvPr/>
        </p:nvSpPr>
        <p:spPr>
          <a:xfrm>
            <a:off x="684360" y="109440"/>
            <a:ext cx="72403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1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BAA7778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59/7.02   Mr obsd/calcd:32824/3560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7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" descr=""/>
          <p:cNvPicPr/>
          <p:nvPr/>
        </p:nvPicPr>
        <p:blipFill>
          <a:blip r:embed="rId1"/>
          <a:stretch/>
        </p:blipFill>
        <p:spPr>
          <a:xfrm>
            <a:off x="609480" y="1295280"/>
            <a:ext cx="830592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51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PlaceHolder 2"/>
          <p:cNvSpPr>
            <a:spLocks noGrp="1"/>
          </p:cNvSpPr>
          <p:nvPr>
            <p:ph/>
          </p:nvPr>
        </p:nvSpPr>
        <p:spPr>
          <a:xfrm>
            <a:off x="533160" y="1219320"/>
            <a:ext cx="8305560" cy="31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KMGFAPMLSV AVLLGTLAAF PAAVHSIGVC YGVVANNLPG PSEVVQLYR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KGIDSMRIYF ADAAALNALS GSNIGLIMDV GNGNLSSLAS SPSAAAGWV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NIQAYPGVS FRYIAVGNEV QGSDTANILP AMRNVNSAL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GLGNI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SV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DAFA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FPPSSGRFR DDYMTPIARF LATTGAPLLA NVYPYFAYK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QESGQKNIM LNYATFQPG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VVDNGN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T YTCLFDAMVD SIYAALE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PSVSVVVSE SGWPSAGGKV GASVNNAQT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QGLINH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 GTPKKRRAL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YIFAMFDEN GKPGDEIE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 FGLFNPN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P SYSISF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2"/>
          <p:cNvSpPr>
            <a:spLocks noGrp="1"/>
          </p:cNvSpPr>
          <p:nvPr>
            <p:ph/>
          </p:nvPr>
        </p:nvSpPr>
        <p:spPr>
          <a:xfrm>
            <a:off x="0" y="1142640"/>
            <a:ext cx="9144000" cy="2438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 ppm    Miss    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1 - 112     1366.6860    1365.6787   1365.6677      8          0                   R.DNIQAYPGVSFR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3 - 133     2219.0950    2218.0877    2218.1052    -8          0                   R.YIAVGNEVQGSDTANILPAMR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4 - 148     1440.8090    1439.8017   1439.8096     -5          0                   R.NVNSALVAAGLGNI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55 - 168     1514.6990    1513.6917   1513.6838      5          0                   R.FDAFADTFPPSSGR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69 - 179     1384.6840    1383.6767   1383.6605     12         1                   R.FRDDYMTPIAR.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0 - 207     3107.4580    3106.4507   3106.5287    -25         1   R.FLATTGAPLLANVYPYFAYKDDQESGQK.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8 - 228     2325.0920    2324.0847   2324.1219    -16         0                   K.NIMLNYATFQPGTTVVDNGN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49 - 269     1958.9550    1957.9477   1957.9745    -14         0   K.AGTPSVSVVVSESGWPSAGG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70 - 289     2155.0540    2154.0467   2154.0930    -21         0                   K.VGASVNNAQTYNQGLINHV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394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20 - 328     1073.5760    1072.5687   1072.5454     22         0                   K.HFGLFNPNK.S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"/>
          <p:cNvSpPr/>
          <p:nvPr/>
        </p:nvSpPr>
        <p:spPr>
          <a:xfrm>
            <a:off x="684360" y="109440"/>
            <a:ext cx="87645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CAA4691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11/5.77   Mr obsd/calcd:34192/3287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7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6" name="" descr=""/>
          <p:cNvPicPr/>
          <p:nvPr/>
        </p:nvPicPr>
        <p:blipFill>
          <a:blip r:embed="rId1"/>
          <a:stretch/>
        </p:blipFill>
        <p:spPr>
          <a:xfrm>
            <a:off x="457200" y="1219320"/>
            <a:ext cx="8305920" cy="4728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47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533160" y="1218960"/>
            <a:ext cx="8305560" cy="373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  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MASATNSSLS LMLLVAAAMA SVASAQLSAT FYDTSCPNAL STI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VITA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NSE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GAS LL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HFHDC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QGCDASVL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GQEQNAGPN VGSLRGFSV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 DNA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RVEAI CNQTVSCADI LAVAA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SV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LGGPSWTV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G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DSTTA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EALANTDLPA PSSSLAELIG NFS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GLDA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MVALSGAHT IGQAQCQNF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RIYNETNID SAFATQRQAN CPRPTGSGDS NLAPVDTTTP NAFDNAYYS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LSN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LLHS DQVLFNGGSA DNTVRNFAS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AFSSAFTT AMVKMGNIS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TGTQGQ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 SCSKVN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9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2"/>
          <p:cNvSpPr>
            <a:spLocks noGrp="1"/>
          </p:cNvSpPr>
          <p:nvPr>
            <p:ph/>
          </p:nvPr>
        </p:nvSpPr>
        <p:spPr>
          <a:xfrm>
            <a:off x="0" y="1143000"/>
            <a:ext cx="9144000" cy="28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 Mr(expt)    Mr(calc)  ppm    Miss                 Sequence</a:t>
            </a:r>
            <a:r>
              <a:rPr b="0" lang="zh-CN" sz="2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5 - 56        1217.6740     1216.6667    1216.6411     21         0                     K.SVITAAVNSEAR.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4 - 95        3512.6390     3511.6317    3511.6362     -1          0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LHFHDCFVQGCDASVLLSGQEQNAGPNVGSLR.G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96 - 104       950.5350       949.5277      949.4869      43         0                     R.GFSVIDNA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7 - 143    1726.9920     1725.9847    1725.9414     25         0                     R.DSVVALGGPSWTVLLGR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75 - 200    2789.3420     2788.3347    2788.3385     -1         1  R.KGLDATDMVALSGAHTIGQAQCQNF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76 - 200    2661.2400     2660.2327    2660.2435     -4          0  K.GLDATDMVALSGAHTIGQAQCQNF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56 - 275    2100.0360     2099.0287    2099.0396     -5          0                     K.GLLHSDQVLFNGGSADNTVR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76 - 294    1935.9550     1934.9477    1934.9196     15         0                     R.NFASNAAAFSSAFTTAMVK.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5 - 309    1572.8490     1571.8417    1571.8090     21         0                     K.MGNISPLTGTQGQI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"/>
          <p:cNvSpPr/>
          <p:nvPr/>
        </p:nvSpPr>
        <p:spPr>
          <a:xfrm>
            <a:off x="684360" y="109440"/>
            <a:ext cx="62499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P_00105403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81/6.42 Mr obsd/calcd:76460/8092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7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609480" y="1219320"/>
            <a:ext cx="8291520" cy="5103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"/>
          <p:cNvSpPr/>
          <p:nvPr/>
        </p:nvSpPr>
        <p:spPr>
          <a:xfrm>
            <a:off x="684360" y="109440"/>
            <a:ext cx="69357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CAA4691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42/5.77   Mr obsd/calcd:33298/32876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6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2" name="" descr=""/>
          <p:cNvPicPr/>
          <p:nvPr/>
        </p:nvPicPr>
        <p:blipFill>
          <a:blip r:embed="rId1"/>
          <a:stretch/>
        </p:blipFill>
        <p:spPr>
          <a:xfrm>
            <a:off x="533520" y="1219320"/>
            <a:ext cx="8305560" cy="4728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44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2"/>
          <p:cNvSpPr>
            <a:spLocks noGrp="1"/>
          </p:cNvSpPr>
          <p:nvPr>
            <p:ph/>
          </p:nvPr>
        </p:nvSpPr>
        <p:spPr>
          <a:xfrm>
            <a:off x="533160" y="1219320"/>
            <a:ext cx="8305560" cy="31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SATNSSLS LMLLVAAAMA SVASAQLSAT FYDTSCPNAL STI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VITA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NSE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GAS LL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HFHDC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QGCDASVLL SGQEQNAGP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GSL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FSV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NAKARVEAI CNQTVSCADI LAVAA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SVV ALGGPSWTVL LG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DSTTA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EALANTDLPA PSSSLAELIG NFS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GLDA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MVALSGAH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GQAQCQNF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RIYNETNID SAFATQRQAN CPRPTGSGDS NLAPVDTTTP NAFDNAYYS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LSN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LLH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QVLFNGGSA DNTVRNFASN AAAFSSAFT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MVKMGNIS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TGTQGQ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 SCSKVN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0" y="1142640"/>
            <a:ext cx="9144000" cy="251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ppm     Miss                 Sequence</a:t>
            </a:r>
            <a:r>
              <a:rPr b="0" lang="zh-CN" sz="20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5 - 56       1217.7050    1216.6977   1216.6411      47         0                    K.SVITAAVNSEAR.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4 - 95       3512.6410    3511.6337   3511.6362      -1          0 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LHFHDCFVQGCDASVLLSGQEQNAGPNVGSLR.G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7 - 143    1727.0220    1726.0147   1725.9414      42         0                    R.DSVVALGGPSWTVLLGR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75 - 200    2789.3870    2788.3797   2788.3385      15         1   R.KGLDATDMVALSGAHTIGQAQCQNF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76 - 200    2661.3040    2660.2967   2660.2435      20         0   K.GLDATDMVALSGAHTIGQAQCQNF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56 - 275    2100.0920    2099.0847   2099.0396      21         0                   K.GLLHSDQVLFNGGSADNTVR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76 - 294    1935.9960    1934.9887   1934.9196      36         0                   R.NFASNAAAFSSAFTTAMVK.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5 - 309    1572.8820    1571.8747   1571.8090      42         0                   K.MGNISPLTGTQGQIR.L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"/>
          <p:cNvSpPr/>
          <p:nvPr/>
        </p:nvSpPr>
        <p:spPr>
          <a:xfrm>
            <a:off x="684360" y="109440"/>
            <a:ext cx="64785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NP_00106062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22/5.51     Mr obsd/calcd:36242/3260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8" name="" descr=""/>
          <p:cNvPicPr/>
          <p:nvPr/>
        </p:nvPicPr>
        <p:blipFill>
          <a:blip r:embed="rId1"/>
          <a:stretch/>
        </p:blipFill>
        <p:spPr>
          <a:xfrm>
            <a:off x="533520" y="1295280"/>
            <a:ext cx="830556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60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533160" y="1218960"/>
            <a:ext cx="8305560" cy="3733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MASASSVSLM LLVAAAMASA ASAQLSATFY DTSCPNALST I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AVTAAV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EP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GASLV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HFHDCFVQ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CDASVLLSG QEQNAGPNAG SLRGFNVVD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KTQVEAICS QTVSCADILA VAARDSVVAL GGPSWTVLL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DSTTANE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QANTDLPAPS SSLAELIGNF S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GLDVTDM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ALSGAHTIG QAQCQNF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YNETNIDSS FATAL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NC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PTGSGDSNL APLDTTTPNA FDSAYYTNLL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NKGLLHSDQ VLFNGGSTD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FSSNTA AFNSAFTAAM V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GNISPLT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TQGQ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NC SKV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PlaceHolder 2"/>
          <p:cNvSpPr>
            <a:spLocks noGrp="1"/>
          </p:cNvSpPr>
          <p:nvPr>
            <p:ph/>
          </p:nvPr>
        </p:nvSpPr>
        <p:spPr>
          <a:xfrm>
            <a:off x="0" y="1143000"/>
            <a:ext cx="9144000" cy="37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 Mr(expt)    Mr(calc)   ppm   Miss                  Sequence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3 - 54           1201.6280     1200.6207    1200.6098     9           0                    K.SAVTAAVNSEPR.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2 - 93           3484.5840     3483.5767     3483.6048   -8           0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LHFHDCFVQGCDASVLLSGQEQNAGPNAGSLR.G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94 - 102         1005.5470     1004.5397    1004.5291    11          0                    R.GFNVVDNI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3 - 124       2363.1580     2362.1507    2362.1621    -5           0 K.TQVEAICSQTVSCADILAVAA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5 - 141       1726.9810     1725.9737    1725.9414    19          0                    R.DSVVALGGPSWTVLLGR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73 - 198       2817.3540     2816.3467    2816.3698     -8          1 R.KGLDVTDMVALSGAHTIGQAQCQNF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74 - 198       2689.2570     2688.2497    2688.2748     -9          0 K.GLDVTDMVALSGAHTIGQAQCQNF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17 - 253       3943.8030     3942.7957    3942.8330     -9          0 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K.ANCPRPTGSGDSNLAPLDTTTPNAFDSAYYTNLLSNK.G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54 - 273       2130.0540     2129.0467    2129.0502     -2          0                    K.GLLHSDQVLFNGGSTDNTVR.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3 - 307       1572.8380     1571.8307    1571.8090     14         0                    K.MGNISPLTGTQGQIR.L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"/>
          <p:cNvSpPr/>
          <p:nvPr/>
        </p:nvSpPr>
        <p:spPr>
          <a:xfrm>
            <a:off x="684360" y="109440"/>
            <a:ext cx="70880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NP_0010640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4.77/4.72     Mr obsd/calcd:42368/3570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4" name="" descr=""/>
          <p:cNvPicPr/>
          <p:nvPr/>
        </p:nvPicPr>
        <p:blipFill>
          <a:blip r:embed="rId1"/>
          <a:stretch/>
        </p:blipFill>
        <p:spPr>
          <a:xfrm>
            <a:off x="609480" y="1295280"/>
            <a:ext cx="8305920" cy="508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39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305920" cy="37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33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ASSSSSSS LAVVVVAAAV ALVAGGGAAV AQLCEEYYDC TCPDAYDIV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VLIDAH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D ARIFASLI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FHDCFVQGC DASLLLDSV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MPSE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SP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NNNSA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FP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DDV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ALED ACPGVVSCAD ILALAAEISV ELSGGPGWG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LGRLDGKTS DFNGSLNLPA PTDNLTVLRQ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AALNLND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LVALSGGHT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GRVQCQFV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YNFSNTG RPDPTMDAAY RSFLSQRCPP NGPPAALND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PTTPDTFDN HYYTNIEVNR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FLQSDQELK SAPEATGTTA PIVDRFATSQ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FFRSFAQS MINMGNLSP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DPSLGE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 NCRRV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0" y="1143000"/>
            <a:ext cx="9144000" cy="536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1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   Observed  Mr(expt)    Mr(calc)    ppm   Miss           Sequence</a:t>
            </a:r>
            <a:r>
              <a:rPr b="0" lang="zh-CN" sz="5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1 - 58              979.5720      978.5647      978.5723       -8        1                 R.RVLIDAHR.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70 - 96            3059.2990     3058.2917    3058.3987     -35       0  R.LHFHDCFVQGCDASLLLDSVPGMPSE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7 - 115          975.5200       974.5127      974.5073        6        0                 R.GFPVVDDV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2 - 203         2287.1370     2286.1297    2286.1757     -20       0  K.FAALNLNDVDLVALSGGHTFGR.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4 - 212         1152.5390    1151.5317     1151.5394      -7        0                 R.VQCQFVTD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71 - 280         1164.5860    1163.5787     1163.5822      -3        0                 R.GFLQSDQEL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81 - 295         1485.7650    1484.7577     1484.7471       7        0                 K.SAPEATGTTAPIVDR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6 - 305         1145.5800    1144.5727     1144.5665       5        0                 R.FATSQAAFFR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06 - 329         2550.1680    2549.1607     2549.2254     -25       0   R.SFAQSMINMGNLSPVTDPSLGEVR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"/>
          <p:cNvSpPr/>
          <p:nvPr/>
        </p:nvSpPr>
        <p:spPr>
          <a:xfrm>
            <a:off x="684360" y="109440"/>
            <a:ext cx="76215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6403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4.63/4.72     Mr obsd/calcd:42033/3570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10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0" name="" descr=""/>
          <p:cNvPicPr/>
          <p:nvPr/>
        </p:nvPicPr>
        <p:blipFill>
          <a:blip r:embed="rId1">
            <a:lum bright="20000"/>
          </a:blip>
          <a:stretch/>
        </p:blipFill>
        <p:spPr>
          <a:xfrm>
            <a:off x="609480" y="1295280"/>
            <a:ext cx="830592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-360" y="51811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40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457200" y="228240"/>
            <a:ext cx="8305920" cy="5181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2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   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AMAARGVLA MVVAVAVVWC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NV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QTPV FACDASNATV SGYGFCDRTK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SSAARAADLL GRLTLAEKVG FLVNKQAALP 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GIPAYEWW SEALHGVSY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 GPGT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STLV PGATSFPQPI LTAASFNASL 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F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IGEVVST EARAMHNVG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LTFWSPN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IFRDP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WGR GQETPGEDPL LAS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AVGYV TGLQDAGGG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 DAL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AACCK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YTAYDVDNW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GVERYTFDA VVSQQDLDD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QPPF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CV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GNVASVMCS YNKVNGKPTC ADKDLLSGVI RGDWKLNGYI VSDCDSVDV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YNNQHYT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DAAAITIKS GLDLNCGNF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QHTVAAVQ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SESDVD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ITNNFIVLM RLGFFDGDPR KLPFGSLGP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VCTSSNQEL AREAARQGI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LKNTGALPL SAKSIKSMAV IGPNANASFT MIGNYEGTPC KYTTPLQGL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NVATVYQPG CTNVGCSGNS LQLSAATQAA ASADVTVLVV GADQSVER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DRTSLLLPG QQPQLVSAVA NAS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PVILV VMSGGPFDIS FAKSSDKIS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LWVGYPGEA GGAALADILF GYHNPGGRLP VTWYPASFAD KVSMTDMRM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DSSTGYPGR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Y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YTGDT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AFGDGLSY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AHSLVSAP EQVAVQLAE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HACHTEHCFS VEAAGEHCGS LSFDVHLRVR NAGGMAGGHT VFLFSSPPS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7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HSAPAKHLLG FEKVSLEPGQ AGVVAFKVDV CKDLSVVDEL GNRKVALGSH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7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LHVGDLKHT LNLR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title"/>
          </p:nvPr>
        </p:nvSpPr>
        <p:spPr>
          <a:xfrm>
            <a:off x="228240" y="44953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58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2"/>
          <p:cNvSpPr>
            <a:spLocks noGrp="1"/>
          </p:cNvSpPr>
          <p:nvPr>
            <p:ph/>
          </p:nvPr>
        </p:nvSpPr>
        <p:spPr>
          <a:xfrm>
            <a:off x="533160" y="1447920"/>
            <a:ext cx="8305560" cy="3504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33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AASSSSSSS LAVVVVAAAV ALVAGGGAAV AQLCEEYYDC TCPDAYDIV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RVLIDAHRSD ARIFASLI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FHDCFVQGC DASLLLDSV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MPSE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SPP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NNNSA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FP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DDVKAALED ACPGVVSCAD ILALAAEISV ELSGGPGWG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LG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DGKTS DFNGSLNLPA PTDNLTVLRQ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AALNLND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LVALSGGHT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GRVQCQFVT D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YNFSNTG RPDPTMDAAY RSFLSQ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CPP NGPPAALND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 DPTTPDTFDN HYYTNIEVNR GFLQSDQELK SAPEATGTTA PIVDRFATSQ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FFRSFAQS MINMGNLSP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DPSLGEV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 NCRRV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/>
          </p:nvPr>
        </p:nvSpPr>
        <p:spPr>
          <a:xfrm>
            <a:off x="0" y="1143000"/>
            <a:ext cx="9144000" cy="536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1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   Observed  Mr(expt)    Mr(calc)  ppm   Miss           Sequence</a:t>
            </a:r>
            <a:r>
              <a:rPr b="0" lang="zh-CN" sz="5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70 – 96           3059.3270     3058.3197   3058.3987   -26        0  R.LHFHDCFVQGCDASLLLDSVPGMPSE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7 - 115         975.5260       974.5187     974.5073      12        0  R.GFPVVDDV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6 - 154         3893.8200    3892.8127   3892.9703    -40        0  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K.AALEDACPGVVSCADILALAAEISVELSGGPGWGVLLGR.L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2 - 203         2287.1610    2286.1537   2286.1757    -10        0  K.FAALNLNDVDLVALSGGHTFGR.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4 - 212         1152.5490    1151.5417   1151.5394      2         0  R.VQCQFVTD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38 - 270         3728.6520    3727.6447   3727.6849    -11        0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CPPNGPPAALNDLDPTTPDTFDNHYYTNIEVNR.G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71 - 280         1164.5950    1163.5877   1163.5822       5        0  R.GFLQSDQEL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81 - 295         1485.7280    1484.7207   1484.7471    -18        0  K.SAPEATGTTAPIVDR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6 - 305         1145.5820    1144.5747   1144.5665       7        0  R.FATSQAAFFR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06 - 329         2550.1860    2549.1787   2549.2254    -18        0  R.SFAQSMINMGNLSPVTDPSLGEVR.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"/>
          <p:cNvSpPr/>
          <p:nvPr/>
        </p:nvSpPr>
        <p:spPr>
          <a:xfrm>
            <a:off x="684360" y="109440"/>
            <a:ext cx="64785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P_00106403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4.64/4.72     Mr obsd/calcd:39602/3570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1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6" name="" descr=""/>
          <p:cNvPicPr/>
          <p:nvPr/>
        </p:nvPicPr>
        <p:blipFill>
          <a:blip r:embed="rId1"/>
          <a:stretch/>
        </p:blipFill>
        <p:spPr>
          <a:xfrm>
            <a:off x="609480" y="1447920"/>
            <a:ext cx="8305920" cy="4728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59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/>
          </p:nvPr>
        </p:nvSpPr>
        <p:spPr>
          <a:xfrm>
            <a:off x="457200" y="1752120"/>
            <a:ext cx="8305920" cy="3429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33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AASSSSSSS LAVVVVAAAV ALVAGGGAAV AQLCEEYYDC TCPDAYDIV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VLIDAH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D ARIFASLI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FHDCFVQGC DASLLLDSVP GMPSEKTSP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NNSARGFPV VDDV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ALED ACPGVVSCAD ILALAAEISV ELSGGPGWG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LGRLDGKTS DFNGSLNLPA PTDNLTVLRQ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AALNLNDV DLVALSGGHT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GRVQCQFVT DRLYNFSNTG RPDPTMDAAY 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FLSQ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CPP NGPPAALND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PTTPDTFDN HYYTNIEVNR GFLQSDQELK SAPEATGTTA PIVDRFATSQ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FFRSFAQS MINMGNLSPV TDPSLGEVR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C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V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/>
          </p:nvPr>
        </p:nvSpPr>
        <p:spPr>
          <a:xfrm>
            <a:off x="0" y="1143000"/>
            <a:ext cx="9144000" cy="536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1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   Observed  Mr(expt)    Mr(calc)    ppm  Miss           Sequence</a:t>
            </a:r>
            <a:r>
              <a:rPr b="0" lang="zh-CN" sz="5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5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1 – 58            979.5630        978.5557     978.5723      -17      1             R.RVLIDAHR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70 - 96            3059.3260      3058.3187    3058.3987    -26      0           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LHFHDCFVQGCDASLLLDSVPGMPSEK.T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97 - 106          1057.4990      1056.4917    1056.4948    -3        0             K.TSPPNNNSA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7 - 115           975.5000       974.4927      974.5073     -15      0             R.GFPVVDDV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2 - 203         2287.1270      2286.1197    2286.1757    -24      0             K.FAALNLNDVDLVALSGGHTFGR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4 - 212         1152.5320      1151.5247   1151.5394     -13      0             R.VQCQFVTD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13 - 231         2188.9040      2187.8967   2188.0007     -48      0             R.LYNFSNTGRPDPTMDAAYR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38 - 270         3728.6300      3727.6227   3727.6849     -17      0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CPPNGPPAALNDLDPTTPDTFDNHYYTNIEVNR.G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71 - 280         1164.5720      1163.5647   1163.5822     -15      0             R.GFLQSDQEL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81 - 295         1485.7300      1484.7227   1484.7471     -16      0             K.SAPEATGTTAPIVDR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96 - 305         1145.5560      1144.5487    1144.5665    -16      0             R.FATSQAAFFR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06 - 329         2550.1900       2549.1827   2549.2254    -17      0           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SFAQSMINMGNLSPVTDPSLGEVR.T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06 - 333         3081.3210       3080.3137   3080.4478    -44      1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SFAQSMINMGNLSPVTDPSLGEVRTNCR.R</a:t>
            </a: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"/>
          <p:cNvSpPr/>
          <p:nvPr/>
        </p:nvSpPr>
        <p:spPr>
          <a:xfrm>
            <a:off x="684360" y="109440"/>
            <a:ext cx="72403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P_00106486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98/5.75 Mr obsd/calcd:36718/35569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2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2" name="" descr=""/>
          <p:cNvPicPr/>
          <p:nvPr/>
        </p:nvPicPr>
        <p:blipFill>
          <a:blip r:embed="rId1"/>
          <a:stretch/>
        </p:blipFill>
        <p:spPr>
          <a:xfrm>
            <a:off x="457200" y="1295280"/>
            <a:ext cx="830592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228240" y="47239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61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533160" y="837720"/>
            <a:ext cx="8305560" cy="358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KEPM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L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GAAGQIGYA LVPMIARGVM LGADQPVILH MLDIPPATE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NGLKMELVD AAFPLLKGIV ATTDVVEACT GVNVAVMVG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P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KEGMERK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VMSKNVSIY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QASALEAH AAPNCKVLVV ANPANTNALI LKEFAPSIPE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ITCLTRLD HNRALGQISE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NVQVTDV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AIIWGNHSS TQYPDVNHA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KTPSGEKPV RELVADDEWL NTEFISTVQQ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AAIIKA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QSSALSAAS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CDH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WVL GTPEGTFVSM GVYSDGSYGV PAGLIYSFPV TCSGGEWTI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QGLPIDEFSR KKMDATAQEL SEEKTLAYSC L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PlaceHolder 2"/>
          <p:cNvSpPr>
            <a:spLocks noGrp="1"/>
          </p:cNvSpPr>
          <p:nvPr>
            <p:ph/>
          </p:nvPr>
        </p:nvSpPr>
        <p:spPr>
          <a:xfrm>
            <a:off x="-360" y="990360"/>
            <a:ext cx="9296280" cy="327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 ppm   Miss  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 - 27       2000.0980    1999.0907   1999.1288    -19        0                  R.VLVTGAAGQIGYALVPMIA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8 - 55       2929.5320     2928.5247   2928.5453    -7         0     R.GVMLGADQPVILHMLDIPPATESLNGLK.M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6 - 67       1346.7300     1345.7227   1345.7315    -7         0                  K.MELVDAAFPLL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8 - 93       2619.3010     2618.2937   2618.3197   -10        0     K.GIVATTDVVEACTGVNVAVMVGGFPR.K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12 - 126     1554.7140     1553.7067   1553.7256   -12        0                  K.SQASALEAHAAPNC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7 - 142     1649.9890     1648.9817   1648.9876    -4         0                  K.VLVVANPANTNALILK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43 - 151     1017.5070     1016.4997   1016.5178  -18         0                  K.EFAPSIPEK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72 - 180     1015.5790     1014.5717   1014.5710    1          0                  K.LNVQVTDVK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1 - 202     2452.1860     2451.1787   2451.1931   -6          0                  K.NAIIWGNHSSTQYPDVNHATV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3 - 211      970.5150       969.5077     969.5243   -17         0                  K.TPSGEKPVR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12 - 231     2393.1380     2392.1307   2392.1547  -10         0                  R.ELVADDEWLNTEFISTVQQR.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40 - 256     1788.8210     1787.8137  1787.8584   -25         1                  R.KQSSALSAASSACDHI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41 - 256     1660.7410     1659.7337  1659.7635   -18         0                  K.QSSALSAASSACDHIR.D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"/>
          <p:cNvSpPr/>
          <p:nvPr/>
        </p:nvSpPr>
        <p:spPr>
          <a:xfrm>
            <a:off x="684360" y="109440"/>
            <a:ext cx="66308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3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P_00105908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80/5.99  Mr obsd/calcd:64162/5724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6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8" name="" descr=""/>
          <p:cNvPicPr/>
          <p:nvPr/>
        </p:nvPicPr>
        <p:blipFill>
          <a:blip r:embed="rId1"/>
          <a:stretch/>
        </p:blipFill>
        <p:spPr>
          <a:xfrm>
            <a:off x="609480" y="1295280"/>
            <a:ext cx="8291520" cy="5104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title"/>
          </p:nvPr>
        </p:nvSpPr>
        <p:spPr>
          <a:xfrm>
            <a:off x="228240" y="47239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53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2"/>
          <p:cNvSpPr>
            <a:spLocks noGrp="1"/>
          </p:cNvSpPr>
          <p:nvPr>
            <p:ph/>
          </p:nvPr>
        </p:nvSpPr>
        <p:spPr>
          <a:xfrm>
            <a:off x="533160" y="1218960"/>
            <a:ext cx="8305560" cy="3886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LRAALLRSG SGLRRPPMAA PLSTAAAASW LSDSASSPPR V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LIGGEFV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SRADEHVDV TNPATQEVVS RIPLTTADE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AVDAARTA FPGWRNTPVT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RQRIMLKYQ ELIRANMDKL AENITTEQGK TL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AWGDV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LEVVEHA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MGTLQMGEY VSNVSNGIDT FSIREPLGVC AGICPFNFPA MIPLWMFPI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VTCGNTFVLK PSEKDPGAAM MLAELAMEAG LP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VLNIVH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THDVVNNIC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DEDIKAVSF VGSNIAGMH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S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SAKGKR VQSNMGA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H AIILPDADR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TLNALIAAG FGAAGQRCMA LSTAVFVGGS EPWEDELVKR ASSLVVNSGM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SDADLGPVI S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QAKERICK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IQSGADNG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LLDG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I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PNFENGNF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PTLLADV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 EMECY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EIF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PVLLLMKAE SLDDAIQIVN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GNGAS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TTSGVSARK FQTDIEAGQV GINVPIPVPL PFFSFTGSKA SFAGDLNFY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AGVQFFTQ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VTQQWKES PAQRVSLSMP TSQK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-360" y="990360"/>
            <a:ext cx="9296280" cy="571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 ppm  Miss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 - 25       2659.2530    2658.2457   2658.3743     -48       1     -.MAMAARGVLAMVVAVAVVWCNNVA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2 - 105     2645.2690    2644.2617   2644.3074     -17       0              R.LGIPAYEWWSEALHGVSYVGPGTR.F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 33 - 143    1131.6000    1130.5927   1130.5931      -0        0              R.AIGEVVSTEA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44 - 164    2358.1660    2357.1587   2357.2103     -22       0              R.AMHNVGLAGLTFWSPNINIF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44 - 167    2726.3490    2725.3417   2725.3911     -18       1              R.AMHNVGLAGLTFWSPNINIFRDPR.W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5 - 204    1941.9390    1940.9317   1940.9480      -8        0              K.YAVGYVTGLQDAGGGSDAL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11 - 221    1411.6380    1410.6307   1410.6204       7        0              K.HYTAYDVDNW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11 - 225    1852.9130    1851.9057   1851.8540      28       1              K.HYTAYDVDNWKGVER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26 - 246    2461.1380    2460.1307   2460.1486      -7        0              R.YTFDAVVSQQDLDDTFQPPF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09 - 319    1142.6030    1141.5957   1141.5979      -2        0              K.NPEDAAAITI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20 - 342    2371.1470    2370.1397   2370.1750     -15       0              K.SGLDLNCGNFLAQHTVAAVQAGK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51 - 361    1291.7110    1290.7037   1290.7118      -6        0              R.AITNNFIVLM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62 - 370    1023.4920    1022.4847   1022.4822       3        0              R.LGFFDGDPR.K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71 - 380    1043.6230    1042.6157   1042.6175      -2        1              R.KLPFGSLGPK.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72 - 380     915.5140      914.5067     914.5226      -17       0              K.LPFGSLGPK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25 - 543    1934.0210    1933.0137   1933.0383     -13       0              R.GPVILVVMSGGPFDISFAK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44 - 578    3559.6620    3558.6547   3558.7896     -38       1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SSDKISAILWVGYPGEAGGAALADILFGYHNPGGR.L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48 - 578    3142.5290    3141.5217   3141.6036     -26       0  K.ISAILWVGYPGEAGGAALADILFGYHNPGG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79 - 591    1494.7670    1493.7597   1493.7555       3        0              R.LPVTWYPASFAD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79 - 598    2315.0840    2314.0767   2314.1126     -16       1              R.LPVTWYPASFADKVSMTDMR.M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99 - 610   1323.6370     1322.6297   1322.6037      20       0              R.MRPDSSTGYPGR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614 - 631   2004.9070     2003.8997   2003.9153      -8        0              R.FYTGDTVYAFGDGLSYTK.F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PlaceHolder 2"/>
          <p:cNvSpPr>
            <a:spLocks noGrp="1"/>
          </p:cNvSpPr>
          <p:nvPr>
            <p:ph/>
          </p:nvPr>
        </p:nvSpPr>
        <p:spPr>
          <a:xfrm>
            <a:off x="228240" y="1066680"/>
            <a:ext cx="9296280" cy="464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ppm   Miss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 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3 - 53      1219.7140    1218.7067   1218.6608    38          0                  R.LLIGGEFVES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4 - 71      1966.9700    1965.9627   1965.9392    12          0                  R.ADEHVDVTNPATQEVVSR.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72 - 81      1162.6520    1161.6447   1161.6030    36          0                  R.IPLTTADEF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4 - 141     965.4780      964.4707     964.4403     32          0                  K.DAWGDVF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34 - 256     2576.2670   2575.2597   2575.2337    10          0                  K.GVLNIVHGTHDVVNNICDDEDIK.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57 - 273     1808.9520   1807.9447   1807.9039    23          0                  K.AVSFVGSNIAGMHIYS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89 - 317     2932.5520   2931.5447   2931.5315     5           1   K.NHAIILPDADRDATLNALIAAGFGAAGQR.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00 - 317     1716.9330   1715.9257   1715.8955    18          0                  R.DATLNALIAAGFGAAGQR.C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18 - 339     2425.1950   2424.1877   2424.1341     22         0                  R.CMALSTAVFVGGSEPWEDELVK.R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18 - 340     2581.2600   2580.2527   2580.2352      7          1                  R.CMALSTAVFVGGSEPWEDELVKR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41 - 362     2118.1430   2117.1357   2117.0674    32          0                  R.ASSLVVNSGMASDADLGPVISK.Q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71 - 381     1101.5620   1100.5547   1100.5574    -2           0                  K.LIQSGADNGAR.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88 - 409     2358.2640   2357.2567   2357.2267    13          0                  R.DIVVPNFENGNFVGPTLLADVK.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17 - 428     1388.8200   1387.8127   1387.7785    25          0                  K.EEIFGPVLLLM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29 - 441     1443.7920   1442.7847   1442.7365    33          0                  K.AESLDDAIQIVNR.N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44 - 459     1587.8340   1586.8267   1586.7689    36          0                  K.YGNGASIFTTSGVSAR.K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60 - 489     3233.7190   3232.7117   3232.7173    -2           1   R.KFQTDIEAGQVGINVPIPVPLPFFSFTGSK.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90 - 501     1289.6660   1288.6587   1288.6088    39          0                  K.ASFAGDLNFYG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02 - 511     1138.6750   1137.6677   1137.6183    43          0                  K.AGVQFFTQIK.T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"/>
          <p:cNvSpPr/>
          <p:nvPr/>
        </p:nvSpPr>
        <p:spPr>
          <a:xfrm>
            <a:off x="684360" y="109440"/>
            <a:ext cx="60213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5874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74/5.52  Mr obsd/calcd:38067/5304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6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4" name="" descr=""/>
          <p:cNvPicPr/>
          <p:nvPr/>
        </p:nvPicPr>
        <p:blipFill>
          <a:blip r:embed="rId1"/>
          <a:stretch/>
        </p:blipFill>
        <p:spPr>
          <a:xfrm>
            <a:off x="457200" y="1371600"/>
            <a:ext cx="8291520" cy="5103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15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0" y="2242080"/>
            <a:ext cx="8915400" cy="256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  mvsdhddg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l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paqwkkvcvv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gggmaglaaa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elrregldv tvleqrggvg gqwlydaat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6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agdplgmagv hssvfaslrl nspresigfs dfpfrptnda ggdarrypvh gellryirdf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2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cdafglmdav rlnttvt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a mapprrdgsl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wavrsrrhg eaeteevfda vvvaighysq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8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prlptvdgmd rwrrkqlhsh syrvpdsfag evvvivgcsv sgaelalelr rvakevhls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4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steetitsa ms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va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yen lhlrpqvehl 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edgtvvfdd gsfvvadaii yctgynysf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fldtngkvtv ddnrvgplye hvfppelaps lsfvgipakv llpvfievqa rwvaqvlsgr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6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rtlpsqeemq raveehs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gm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eaaglpk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wt hdmfldlerc ddsgertcgf p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meqw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kei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2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ffsslsdmvd dmesfrdgyh dsdlvrdglr rhgwtpvapr pqeedddaka igvani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0" name="" descr=""/>
          <p:cNvPicPr/>
          <p:nvPr/>
        </p:nvPicPr>
        <p:blipFill>
          <a:blip r:embed="rId1"/>
          <a:stretch/>
        </p:blipFill>
        <p:spPr>
          <a:xfrm>
            <a:off x="533520" y="1523880"/>
            <a:ext cx="7819920" cy="4038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"/>
          <p:cNvSpPr/>
          <p:nvPr/>
        </p:nvSpPr>
        <p:spPr>
          <a:xfrm>
            <a:off x="684360" y="109440"/>
            <a:ext cx="6783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P_00105413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4.77/5.01     Mr obsd/calcd:56057/2730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12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2" name="" descr=""/>
          <p:cNvPicPr/>
          <p:nvPr/>
        </p:nvPicPr>
        <p:blipFill>
          <a:blip r:embed="rId1"/>
          <a:stretch/>
        </p:blipFill>
        <p:spPr>
          <a:xfrm>
            <a:off x="609480" y="1447920"/>
            <a:ext cx="8305920" cy="4728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228240" y="44953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61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609480" y="1447560"/>
            <a:ext cx="8229600" cy="2361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33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ARCTLLVLL VAAAVAVVPL AAGQPWATCG DGTYEQGSAY ENNLLNLALT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L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GASSQE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FSTGSNGAA PNTVYGLLLC RGDISRAAC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CGTSVW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SACR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KD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LVYNECYAR LSDKDDFLA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GPGQLTTL MSSTNISSG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VAAYDRAVT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LAATAEY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DIARKLFA TGQRVGADPG FPNLYATAQC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FDITLEACR GCLEGLVARW WDTFPANVD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AGPRCLL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EVYPFYT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PMVVLR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2"/>
          <p:cNvSpPr>
            <a:spLocks noGrp="1"/>
          </p:cNvSpPr>
          <p:nvPr>
            <p:ph/>
          </p:nvPr>
        </p:nvSpPr>
        <p:spPr>
          <a:xfrm>
            <a:off x="0" y="990720"/>
            <a:ext cx="9144000" cy="4983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- End   Observed  Mr(expt)   Mr(calc) ppm  Miss              Sequenc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53 - 81          2998.3750    2997.3677   2997.4502   -28     0      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R.DGASSQEILFSTGSNGAAPNTVYGLLLCR.G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82 - 98          1973.9520    1972.9447   1972.8520    47     1      R.GDISRAACYDCGTSVWR.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87 - 98          1445.6180    1444.6107   1444.5864    17     0      R.AACYDCGTSVWR.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07 - 120       1671.8360    1670.8287   1670.8086    12     1      R.AKDVALVYNECYAR.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09 - 120       1472.6990    1471.6917   1471.6765    10     0      K.DVALVYNECYAR.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21 - 131       1266.6600    1265.6527   1265.6139    31     1      R.LSDKDDFLADK.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62 - 176       1505.8170    1504.8097   1504.7885    14     0      R.LLAATAEYAAGDIAR.K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77 - 184        920.5740      919.5667     919.5239     47     1      R.KLFATGQR.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85 - 210        2857.2750    2856.2677   2856.3211  -19     0      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R.VGADPGFPNLYATAQCAFDITLEACR.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11 - 219         974.5240      973.5167     973.5015    16     0      R.GCLEGLVAR.W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20 - 232       1534.7310     1533.7237   1533.7001   15     0      R.WWDTFPANVDGAR.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42 - 257       1828.9190     1827.9117   1827.9229    -6     0      R.SEVYPFYTGAPMVVLR.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42 - 258       1957.9660     1956.9587   1956.9655    -3     1      R.SEVYPFYTGAPMVVLRE.-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"/>
          <p:cNvSpPr/>
          <p:nvPr/>
        </p:nvSpPr>
        <p:spPr>
          <a:xfrm>
            <a:off x="684360" y="109440"/>
            <a:ext cx="70880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NP_00105413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4.77/5.01     Mr obsd/calcd:42368/2730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7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98" name="" descr=""/>
          <p:cNvPicPr/>
          <p:nvPr/>
        </p:nvPicPr>
        <p:blipFill>
          <a:blip r:embed="rId1"/>
          <a:stretch/>
        </p:blipFill>
        <p:spPr>
          <a:xfrm>
            <a:off x="609480" y="1371600"/>
            <a:ext cx="830592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title"/>
          </p:nvPr>
        </p:nvSpPr>
        <p:spPr>
          <a:xfrm>
            <a:off x="228240" y="44953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36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2"/>
          <p:cNvSpPr>
            <a:spLocks noGrp="1"/>
          </p:cNvSpPr>
          <p:nvPr>
            <p:ph/>
          </p:nvPr>
        </p:nvSpPr>
        <p:spPr>
          <a:xfrm>
            <a:off x="609480" y="1447560"/>
            <a:ext cx="8229600" cy="2971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33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ARCTLLVLL VAAAVAVVPL AAGQPWATCG DGTYEQGSAY ENNLLNLALT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LRDGASSQEI LFSTGSNGAA PNTVYGLLLC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DISRAAC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CGTSVW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SACR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KD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LVYNECYA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SDKDDFLAD KVGPGQLTTL MSSTNISSG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DVAAYDRAVT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LAATAEY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DIARKLF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GQ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GADPG FPNLYATAQ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FDITLEACR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CLEGLVARW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WDTFPANVD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AGPRCLL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EVYPFYT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PMVVLRE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2"/>
          <p:cNvSpPr>
            <a:spLocks noGrp="1"/>
          </p:cNvSpPr>
          <p:nvPr>
            <p:ph/>
          </p:nvPr>
        </p:nvSpPr>
        <p:spPr>
          <a:xfrm>
            <a:off x="0" y="1219320"/>
            <a:ext cx="9144000" cy="536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  Observed    Mr(expt)    Mr(calc)    ppm    Miss           Sequence</a:t>
            </a:r>
            <a:r>
              <a:rPr b="0" lang="zh-CN" sz="3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82 - 98          1973.8980   1972.8907  1972.8520   20         1            R.GDISRAACYDCGTSVWR.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87 - 98          1445.5600   1444.5527  1444.5864  -23         0            R.AACYDCGTSVWR.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07 - 120       1671.7690   1670.7617  1670.8086  -28         1            R.AKDVALVYNECYAR.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09 - 120       1472.6430   1471.6357  1471.6765  -28         0            K.DVALVYNECYAR.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62 - 176       1505.7600   1504.7527  1504.7885  -24         0            R.LLAATAEYAAGDIAR.K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77 - 184        920.5060     919.4987     919.5239  -27         1            R.KLFATGQR.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11 - 219        974.4990     973.4917     973.5015  -10         0            R.GCLEGLVAR.W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20 - 232       1534.6730   1533.6657  1533.7001  -22         0            R.WWDTFPANVDGAR.I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42 - 257       1828.8620   1827.8547  1827.9229  -37         0            R.SEVYPFYTGAPMVVLR.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42 - 258       1957.8960   1956.8887  1956.9655  -39         1            R.SEVYPFYTGAPMVVLRE.-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"/>
          <p:cNvSpPr/>
          <p:nvPr/>
        </p:nvSpPr>
        <p:spPr>
          <a:xfrm>
            <a:off x="684360" y="109440"/>
            <a:ext cx="72403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0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P_001054038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6.01/6.42 Mr obsd/calcd:74992/80921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4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" descr=""/>
          <p:cNvPicPr/>
          <p:nvPr/>
        </p:nvPicPr>
        <p:blipFill>
          <a:blip r:embed="rId1"/>
          <a:stretch/>
        </p:blipFill>
        <p:spPr>
          <a:xfrm>
            <a:off x="533520" y="1295280"/>
            <a:ext cx="830556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"/>
          <p:cNvSpPr/>
          <p:nvPr/>
        </p:nvSpPr>
        <p:spPr>
          <a:xfrm>
            <a:off x="684360" y="109440"/>
            <a:ext cx="77738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NP_001054135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4.57/5.01     Mr obsd/calcd:35248/2730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4" name="" descr=""/>
          <p:cNvPicPr/>
          <p:nvPr/>
        </p:nvPicPr>
        <p:blipFill>
          <a:blip r:embed="rId1"/>
          <a:stretch/>
        </p:blipFill>
        <p:spPr>
          <a:xfrm>
            <a:off x="609480" y="1295280"/>
            <a:ext cx="830592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63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305920" cy="37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ARCTLLVLL VAAAVAVVPL AAGQPWATCG DGTYEQGSAY ENNLLNLALT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L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GASSQE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FSTGSNGAA PNTVYGLLLC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DIS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C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CGTSVW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GSACR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KDV ALVYNECYAR LSDKDDFLAD KVGPGQLTTL MSSTNISSG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VAAYD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VT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LAATAEY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DI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KLFA TGQ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GADP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PNLYATAQC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FDITLEAC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CLEGLVA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W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WDTFPANVD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AGPRCLL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EVYPFYT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PMVVLRE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PlaceHolder 2"/>
          <p:cNvSpPr>
            <a:spLocks noGrp="1"/>
          </p:cNvSpPr>
          <p:nvPr>
            <p:ph/>
          </p:nvPr>
        </p:nvSpPr>
        <p:spPr>
          <a:xfrm>
            <a:off x="0" y="1143000"/>
            <a:ext cx="9144000" cy="449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Observed  Mr(expt)    Mr(calc)   ppm   Miss          Sequence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3 - 81         2998.4270   2997.4197     2997.4502  -10        0 R.DGASSQEILFSTGSNGAAPNTVYGLLLC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7 - 98        1445.6380    1444.6307     1444.5864   31        0              R.AACYDCGTSVW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7 - 120     1671.8580    1670.8507     1670.8086   25        1              R.AKDVALVYNECYAR.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9 - 120     1472.7200    1471.7127     1471.6765   25        0              K.DVALVYNECYAR.L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1 - 131     1266.6570    1265.6497     1265.6139   28        1              R.LSDKDDFLADK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5 - 157     3415.4890    3414.4817     3414.6249  -42        1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DDFLADKVGPGQLTTLMSSTNISSGADVAAYDR.A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62 - 176     1505.8250    1504.8177     1504.7885   19        0              R.LLAATAEYAAGDIAR.K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85 - 210      2857.3060   2856.2987      2856.3211   -8        0 R.VGADPGFPNLYATAQCAFDITLEAC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20 - 232     1534.7580    1533.7507     1533.7001    33       0              R.WWDTFPANVDGAR.I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42 - 258     1957.9900    1956.9827     1956.9655     9        1              R.SEVYPFYTGAPMVVLRE.-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"/>
          <p:cNvSpPr/>
          <p:nvPr/>
        </p:nvSpPr>
        <p:spPr>
          <a:xfrm>
            <a:off x="684360" y="109440"/>
            <a:ext cx="59450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BB479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70/8.78   Mr obsd/calcd:30236/58748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0" name="" descr=""/>
          <p:cNvPicPr/>
          <p:nvPr/>
        </p:nvPicPr>
        <p:blipFill>
          <a:blip r:embed="rId1"/>
          <a:stretch/>
        </p:blipFill>
        <p:spPr>
          <a:xfrm>
            <a:off x="533520" y="1295280"/>
            <a:ext cx="8291520" cy="5104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380880" y="30456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/>
          </p:nvPr>
        </p:nvSpPr>
        <p:spPr>
          <a:xfrm>
            <a:off x="228240" y="1219320"/>
            <a:ext cx="89154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9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1447920" y="5257800"/>
            <a:ext cx="3581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 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24%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304920" y="2334240"/>
            <a:ext cx="8610480" cy="283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  mslhccpaag dppapagtae ellerarslv paaldaaraa tgfggrw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i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arlervppc</a:t>
            </a: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61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 lsdlsshpcf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s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nslcrell qsvaatlaea aelgarcrep prag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lqmqs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dldalag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d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2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lnl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dcalli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tgvlsdatv ppvapaaeaa aqtdvrella 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lqighaeak h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vdglld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181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lrede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svls algrgnvaal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qlltatap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irekaatvlc llaesgscec llvsegalpp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24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lirlvesgsl vgrekavitl q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lsmspdia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ivghsgvr plidicqtgd sisqsaaag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lknlsavpev rqalaeegiv 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mvnlldcg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vvlgc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eyaa eclqsltssn dglr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ravvse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36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gglr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sllayl dgplpqesav galrnlvssa ispdslvslg vlprlvhvlr egsvgaqqa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2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aaaicrvsss semkrlvgeh gcmpllvrll eaksngarev aaqavaslms clanardikk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48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deksvpnlvq llepspqnta k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yaiscllt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lsas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rckkl mishgaigyl kk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lsemdvag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541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zh-CN" sz="1800" spc="-1" strike="noStrike">
                <a:solidFill>
                  <a:srgbClr val="ff3300"/>
                </a:solidFill>
                <a:latin typeface="Arial"/>
              </a:rPr>
              <a:t>ak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kllekler gklrnlfsrk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6019920" y="5410080"/>
            <a:ext cx="2286000" cy="3288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PlaceHolder 1"/>
          <p:cNvSpPr>
            <a:spLocks noGrp="1"/>
          </p:cNvSpPr>
          <p:nvPr>
            <p:ph type="title"/>
          </p:nvPr>
        </p:nvSpPr>
        <p:spPr>
          <a:xfrm>
            <a:off x="533520" y="4568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7" name="" descr=""/>
          <p:cNvPicPr/>
          <p:nvPr/>
        </p:nvPicPr>
        <p:blipFill>
          <a:blip r:embed="rId1"/>
          <a:stretch/>
        </p:blipFill>
        <p:spPr>
          <a:xfrm>
            <a:off x="685800" y="1447920"/>
            <a:ext cx="7924680" cy="4267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"/>
          <p:cNvSpPr/>
          <p:nvPr/>
        </p:nvSpPr>
        <p:spPr>
          <a:xfrm>
            <a:off x="684360" y="109440"/>
            <a:ext cx="74689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EAY76707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5.98/6.14 Mr obsd/calcd:67024/5790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16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9" name="" descr=""/>
          <p:cNvPicPr/>
          <p:nvPr/>
        </p:nvPicPr>
        <p:blipFill>
          <a:blip r:embed="rId1"/>
          <a:stretch/>
        </p:blipFill>
        <p:spPr>
          <a:xfrm>
            <a:off x="609480" y="1295280"/>
            <a:ext cx="830592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0" name="PlaceHolder 1"/>
          <p:cNvSpPr>
            <a:spLocks noGrp="1"/>
          </p:cNvSpPr>
          <p:nvPr>
            <p:ph type="title"/>
          </p:nvPr>
        </p:nvSpPr>
        <p:spPr>
          <a:xfrm>
            <a:off x="228240" y="47239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52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2"/>
          <p:cNvSpPr>
            <a:spLocks noGrp="1"/>
          </p:cNvSpPr>
          <p:nvPr>
            <p:ph/>
          </p:nvPr>
        </p:nvSpPr>
        <p:spPr>
          <a:xfrm>
            <a:off x="533160" y="837720"/>
            <a:ext cx="8305560" cy="358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SPPPLRLLL FLLLLHLPSS LSSRHHHHAP SPSKPAPASY AAPLAVLLAC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NATRFQPACV STLSNASADA STPDLLAATL SALRARIPPA VSTARSVLA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SSNVNLTNAA TNCLTFLSLS TH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SPPPS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SPSLLSAST ALLHLYDCW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Y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YVNFSRT ISDAMAYLDD TIAVNSNYIS MLAALQRYGD DTFRWAPPQT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E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GYWPPA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SAADEDA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VP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LPPNV TVCGAGCHYK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VGEAVAAA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YGDEMFVVH VKEGVYKET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VPWE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NVV VVGDGMG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TGDLNADT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VSTFNTATV GVLADGFMAR DLTISNTAG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AHQAVAF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 TGD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VLDT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LLGHQDTL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HAM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QFYTR C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SGTVDF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GNSATVLR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ALIVLP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Q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RPEKGENDAV TAQG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DPAQ PTGIVL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CV VNGSDDYMAL Y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KPDVHH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LGRPW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YS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VYVGCTL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IVQPRGWMA WNGDFALKTL YYGEYESAGP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GDGASGSRI GWSSQVPRDH VDVYSVASF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QGD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WIPKIH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2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PlaceHolder 2"/>
          <p:cNvSpPr>
            <a:spLocks noGrp="1"/>
          </p:cNvSpPr>
          <p:nvPr>
            <p:ph/>
          </p:nvPr>
        </p:nvSpPr>
        <p:spPr>
          <a:xfrm>
            <a:off x="-360" y="990720"/>
            <a:ext cx="9296280" cy="4419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ppm   Miss             Sequence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24 - 153     3249.6150   3248.6077   3248.6063      0         0   R.LSPPPSTSSPSLLSASTALLHLYDCWSAYK.Y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03 - 224     2158.0680   2157.0607   2157.0015     27        0                 R.DGYWPPAAAGSAADEDALGVPK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41 - 262     2305.1900   2304.1827   2304.1096     32        0                 K.TVGEAVAAAPDYGDEMFVVHVK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63 - 276     1677.9130   1676.9057   1676.8410     39        1                 K.EGVYKETVNVPWEK.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68 - 276     1101.6110   1100.6037   1100.5502     49        0                 K.ETVNVPWE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89 - 320     3211.5770   3210.5697   3210.5867     -5         0 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K.TVITGDLNADTPGVSTFNTATVGVLADGFMAR.D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21 - 339     1984.0250   1983.0177   1982.9810     19        0                 R.DLTISNTAGPDAHQAVAFR.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45 - 365     2383.2490   2382.2417   2382.2002     17        0                 R.TVLDTVELLGHQDTLYAHAMR.Q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73 - 389     1768.9530   1767.9457   1767.9156     17        0                 R.VSGTVDFVFGNSATVL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390 - 398      997.6470     996.6397     996.5968      43        0                 R.DTALIVLPR.Q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16 – 427    1267.7510   1266.7437   1266.6932    40         0                 R.TDPAQPTGIVL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43 - 457     1861.0390    1860.0317   1859.9795    28         0                 R.EKPDVHHVYLGRPWK.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62 - 476     1721.9290    1720.9217   1720.8818    23         0                 R.TVYVGCTLSEIVQP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77 - 488     1395.7090    1394.7017   1394.6441    41         0                 R.GWMAWNGDFALK.T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89 - 509     2093.9500    2092.9427   2092.8974    22         0                 K.TLYYGEYESAGPGGDGASGSR.I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10 - 518    1029.5930    1028.5857   1028.5403     44         0                 R.IGWSSQVP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19 - 534    1779.9000    1778.8927   1778.8475     25         0                 R.DHVDVYSVASFIQGDK.W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"/>
          <p:cNvSpPr/>
          <p:nvPr/>
        </p:nvSpPr>
        <p:spPr>
          <a:xfrm>
            <a:off x="684360" y="109440"/>
            <a:ext cx="70880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NP_00105881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 4.18/4.55 Mr obsd/calcd:19004/17534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7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5" name="" descr=""/>
          <p:cNvPicPr/>
          <p:nvPr/>
        </p:nvPicPr>
        <p:blipFill>
          <a:blip r:embed="rId1"/>
          <a:stretch/>
        </p:blipFill>
        <p:spPr>
          <a:xfrm>
            <a:off x="609480" y="1219320"/>
            <a:ext cx="8305920" cy="4728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228240" y="571464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37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304920" y="380520"/>
            <a:ext cx="8534160" cy="54104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AMAARGVLA MVVAVAVVWC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NV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QTPV FACDASNATV SGYGFCDRTK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SSAARAADLL GRLTLAEKVG FLVNKQAALP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GIPAYEWW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EALHGVSY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PGT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STLV PGATSFPQPI LTAASFNASL F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IGEVVST EARAMHNVG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LTFWSPN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IF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PRWGR GQETPGEDPL LAS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AVGY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GLQDAGGG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AL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AACCK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HYTAYDVDNW 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GVE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TFD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VSQQDLDDT FQPPFKSCV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GNVASVMCS YN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NGKPTC ADKDLLSGVI RGDWKLNGYI VSDCDSVDV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YNNQHYTKNP EDAAAITI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LDLNCGNFL AQHTVAAVQ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LSESDVD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ITNNFIVLM RLGFFDGDPR KLPFGSLGP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VCTSSNQEL AREAARQGI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LKNTGALPL SAKSIKSMAV IGPNANASFT MIGNYEGTPC KYTTPLQGL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ANVATVYQPG CTNVGCSGNS LQLSAATQAA ASADVTVLVV GADQSVERE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LDRTSLLLPG QQPQLVSAVA NAS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PVIL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MSGGPFDIS FAKSSDKIS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ILWVGYPGEA GGAALADILF GYHNPGGRLP VTWYPASFA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SMTDMRMR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PDSSTGYPGR TY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YTGDT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AFGDGLSY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FAHSLVSAP EQVAVQLAEG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6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HACHTEHCFS VEAAGEHCGS LSFDVHLRVR NAGGMAGGHT VFLFSSPPS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7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HSAPAKHLLG FEKVSLEPGQ AGVVAFKVDV CKDLSVVDEL GNRKVALGSH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7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TLHVGDLKHT LNLR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228240" y="472392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68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PlaceHolder 2"/>
          <p:cNvSpPr>
            <a:spLocks noGrp="1"/>
          </p:cNvSpPr>
          <p:nvPr>
            <p:ph/>
          </p:nvPr>
        </p:nvSpPr>
        <p:spPr>
          <a:xfrm>
            <a:off x="533160" y="838080"/>
            <a:ext cx="8305560" cy="28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MASSSSRLSC CLLVLAAAAM AATAQNSAQD FVDPHNAA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 DVGVGPVSW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TVAAYAESY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Q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QGDCKL EHSDSGG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NIFWGSAGG DWTAASAVS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WVSEKQWYDH GSNSCSAPEG SSCGHYTQVV WRDSTAIGCA RVVCDGDLGV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ITCNYSPPG NFVGQSPY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380880" y="228240"/>
            <a:ext cx="8229600" cy="7621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/>
          </p:nvPr>
        </p:nvSpPr>
        <p:spPr>
          <a:xfrm>
            <a:off x="-360" y="1066680"/>
            <a:ext cx="9296280" cy="2286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Start - End  Observed  Mr(expt)   Mr(calc)   ppm   Miss             Sequence</a:t>
            </a:r>
            <a:r>
              <a:rPr b="0" lang="zh-CN" sz="3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40 - 64       2598.2130   2597.2057   2597.2034      1          0          R.ADVGVGPVSWDDTVAAYAESYAAQR.Q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79 - 105     2846.3860   2845.3787   2845.2984      28         0    K.YGENIFWGSAGGDWTAASAVSAWVSEK.Q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6 - 132    3155.3600  3154.3527   3154.3046       15         0    K.QWYDHGSNSCSAPEGSSCGHYTQVVWR.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3 - 141     950.4360    949.4287     949.4287       -0           0         R.DSTAIGCAR.V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42 - 168    2962.4630  2961.4557   2961.3314      42          0         R.VVCDGDLGVFITCNYSPPGNFVGQSPY.-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"/>
          <p:cNvSpPr/>
          <p:nvPr/>
        </p:nvSpPr>
        <p:spPr>
          <a:xfrm>
            <a:off x="684360" y="109440"/>
            <a:ext cx="678312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4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EAY79390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4.87/6.09   Mr obsd/calcd:27826/2753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8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1" name="" descr=""/>
          <p:cNvPicPr/>
          <p:nvPr/>
        </p:nvPicPr>
        <p:blipFill>
          <a:blip r:embed="rId1"/>
          <a:stretch/>
        </p:blipFill>
        <p:spPr>
          <a:xfrm>
            <a:off x="609480" y="1371600"/>
            <a:ext cx="830592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60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2"/>
          <p:cNvSpPr>
            <a:spLocks noGrp="1"/>
          </p:cNvSpPr>
          <p:nvPr>
            <p:ph/>
          </p:nvPr>
        </p:nvSpPr>
        <p:spPr>
          <a:xfrm>
            <a:off x="533160" y="1219320"/>
            <a:ext cx="8305560" cy="31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TTTTARFVQ LAACAAAALL AVAASGAAAQ GVGSVITQAV FNSMLPNRD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SQCPA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FY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DAFIAAANS FPAFGTSGGS AELIRRELAA FFGQTSHET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GTRGSSDQF QWGYCFKEEI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TSPPYYG 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PIQLTGQS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YQAAGNAL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DLVGNPDLV STDAVVSFK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IWFWMTAQG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KPSCHDVIL GRWTPSAADT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AG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PGYGV ITNIINGGIE CGVGQNDANV DRIGYYK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YC DMLGTGYGS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DCYNQ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NFA S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0" y="1143000"/>
            <a:ext cx="9144000" cy="281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- End  Observed  Mr(expt)   Mr(calc)   ppm   Miss                 Sequence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57 - 85         3001.4450       3000.4377      3000.4294       3           0    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R.GFYTYDAFIAAANSFPAFGTSGGSAELIR.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6 - 104       2066.0230       2065.0157      2064.9977       9           1             R.RELAAFFGQTSHETTGGT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87 - 104       1909.9160       1908.9087      1908.8966       6           0             R.ELAAFFGQTSHETTGGTR.G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5 - 117      1609.7120       1608.7047      1608.6667      24          0             R.GSSDQFQWGYCFK.E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05 - 122      2223.0030       2221.9957      2221.9739      10          1             R.GSSDQFQWGYCFKEEINK.A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224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32 - 169      3829.8360       3828.8287      3828.9534     -33          0    </a:t>
            </a:r>
            <a:r>
              <a:rPr b="1" lang="zh-CN" sz="900" spc="-1" strike="noStrike">
                <a:solidFill>
                  <a:srgbClr val="000000"/>
                </a:solidFill>
                <a:latin typeface="Arial"/>
              </a:rPr>
              <a:t>R.GPIQLTGQSNYQAAGNALGLDLVGNPDLVSTDAVVSFK.T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70 - 192      2688.3050       2687.2977      2687.3101       -5          0    K.TAIWFWMTAQGNKPSCHDVILGR.W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193 – 204     1203.5880       1202.5807      1202.5680       11         0             R.WTPSAADTAAGR.V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3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239 - 257      2286.9480       2285.9407      2285.9140       12         0    R.YCDMLGTGYGSNLDCYNQR.N</a:t>
            </a:r>
            <a:r>
              <a:rPr b="0" lang="zh-CN" sz="1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6" name=""/>
          <p:cNvSpPr/>
          <p:nvPr/>
        </p:nvSpPr>
        <p:spPr>
          <a:xfrm>
            <a:off x="684360" y="109440"/>
            <a:ext cx="762156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5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NP_00104747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02/5.07     Mr obsd/calcd:42033/36993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37" name="" descr=""/>
          <p:cNvPicPr/>
          <p:nvPr/>
        </p:nvPicPr>
        <p:blipFill>
          <a:blip r:embed="rId1"/>
          <a:stretch/>
        </p:blipFill>
        <p:spPr>
          <a:xfrm>
            <a:off x="533520" y="1295280"/>
            <a:ext cx="8305560" cy="47293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39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305920" cy="373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ff33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MASEGVLLGM GNPLLDISAV VDDAFLTKYD VKLNNAILAE EKHLPMYDEL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AS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NVEYIA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GATQNSI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V AQWMLQTPGA TSYMGCIGKD 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KFGEEMK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N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QAAGVTAHYY EDEAAPTGTC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VCVVGGE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 LVANLSAANC YKSEHLKKP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NWALVEKAKY IYIAGFFLTV SPDSIQLVAE HAAANN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FL MNLSAPFIC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F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AQE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V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PFVDYIFGNE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EA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FAKVR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WETENVEEI AL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SQLPL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2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SGKQKRIAVI TQGADPVVVA EDGQV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FPV ILLP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E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V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NGAGDAFV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01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GFLSQLVQQ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IEDSV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AGC YAANVIIQ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 GCTYPEKPDF 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title"/>
          </p:nvPr>
        </p:nvSpPr>
        <p:spPr>
          <a:xfrm>
            <a:off x="457200" y="304920"/>
            <a:ext cx="8229600" cy="761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Matched Peptides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2"/>
          <p:cNvSpPr>
            <a:spLocks noGrp="1"/>
          </p:cNvSpPr>
          <p:nvPr>
            <p:ph/>
          </p:nvPr>
        </p:nvSpPr>
        <p:spPr>
          <a:xfrm>
            <a:off x="0" y="1143000"/>
            <a:ext cx="9144000" cy="4495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800" spc="-1" strike="noStrike">
                <a:solidFill>
                  <a:srgbClr val="000000"/>
                </a:solidFill>
                <a:latin typeface="Arial"/>
              </a:rPr>
              <a:t>Start - End Observed  Mr(expt)    Mr(calc)  ppm   Miss           Sequence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54 - 69         1649.8560   1648.8487   1648.8169    19        0             K.GNVEYIAGGATQNSIR.V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2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99 - 129       3224.3710   3223.3637   3223.4299    -21       0    </a:t>
            </a:r>
            <a:r>
              <a:rPr b="1" lang="zh-CN" sz="1000" spc="-1" strike="noStrike">
                <a:solidFill>
                  <a:srgbClr val="000000"/>
                </a:solidFill>
                <a:latin typeface="Arial"/>
              </a:rPr>
              <a:t>K.NAQAAGVTAHYYEDEAAPTGTCAVCVVGGER.S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188 - 203      1990.9920   1989.9847   1989.9845      0        0             K.VFLMNLSAPFICEFFR.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09 - 224      1869.9620   1868.9547   1868.9309     13       0             K.VLPFVDYIFGNETEAR.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31 - 243      1517.7820   1516.7747   1516.7409     22       0             R.GWETENVEEIALK.I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77 - 285      1027.6450   1026.6377   1026.6478    -10       0             K.TFPVILLPK.E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3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288 - 310      2364.1850   2363.1777   2363.2122    -15       0   </a:t>
            </a:r>
            <a:r>
              <a:rPr b="1" lang="zh-CN" sz="1400" spc="-1" strike="noStrike">
                <a:solidFill>
                  <a:srgbClr val="000000"/>
                </a:solidFill>
                <a:latin typeface="Arial"/>
              </a:rPr>
              <a:t>K.LVDTNGAGDAFVGGFLSQLVQQK.S</a:t>
            </a:r>
            <a:r>
              <a:rPr b="1" lang="zh-CN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zh-CN" sz="1600" spc="-1" strike="noStrike">
                <a:solidFill>
                  <a:srgbClr val="000000"/>
                </a:solidFill>
                <a:latin typeface="Arial"/>
              </a:rPr>
              <a:t>318 - 329      1335.7080   1334.7007   1334.6765     18       0             K.AGCYAANVIIQR.S</a:t>
            </a:r>
            <a:r>
              <a:rPr b="0" lang="zh-CN" sz="16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"/>
          <p:cNvSpPr/>
          <p:nvPr/>
        </p:nvSpPr>
        <p:spPr>
          <a:xfrm>
            <a:off x="684360" y="109440"/>
            <a:ext cx="5945040" cy="108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pot No.: </a:t>
            </a:r>
            <a:r>
              <a:rPr b="1" lang="zh-CN" sz="1800" spc="-1" strike="noStrike">
                <a:solidFill>
                  <a:srgbClr val="0000ff"/>
                </a:solidFill>
                <a:latin typeface="Times New Roman"/>
              </a:rPr>
              <a:t>5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NCBI accession No.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  BAD29182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PI obsd/calcd:5.33/8.87   Mr obsd/calcd:33588/1936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Times New Roman"/>
              </a:rPr>
              <a:t>Score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7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3" name="" descr=""/>
          <p:cNvPicPr/>
          <p:nvPr/>
        </p:nvPicPr>
        <p:blipFill>
          <a:blip r:embed="rId1"/>
          <a:stretch/>
        </p:blipFill>
        <p:spPr>
          <a:xfrm>
            <a:off x="609480" y="1219320"/>
            <a:ext cx="8305920" cy="4728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PlaceHolder 1"/>
          <p:cNvSpPr>
            <a:spLocks noGrp="1"/>
          </p:cNvSpPr>
          <p:nvPr>
            <p:ph type="title"/>
          </p:nvPr>
        </p:nvSpPr>
        <p:spPr>
          <a:xfrm>
            <a:off x="380520" y="4419360"/>
            <a:ext cx="84582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equence Coverage: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59%</a:t>
            </a: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2"/>
          <p:cNvSpPr>
            <a:spLocks noGrp="1"/>
          </p:cNvSpPr>
          <p:nvPr>
            <p:ph/>
          </p:nvPr>
        </p:nvSpPr>
        <p:spPr>
          <a:xfrm>
            <a:off x="533160" y="1219320"/>
            <a:ext cx="8305560" cy="312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600" spc="-1" strike="noStrike">
                <a:solidFill>
                  <a:srgbClr val="000000"/>
                </a:solidFill>
                <a:latin typeface="Arial"/>
              </a:rPr>
              <a:t>Matched peptides shown in </a:t>
            </a:r>
            <a:r>
              <a:rPr b="1" lang="en-US" sz="3600" spc="-1" strike="noStrike">
                <a:solidFill>
                  <a:srgbClr val="ff3300"/>
                </a:solidFill>
                <a:latin typeface="Arial"/>
              </a:rPr>
              <a:t>Bold Red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9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MEGKPSGLPS STGGKGKGVP VVGANPWHSD DGCDGSKSSR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LMTLTIVIY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51  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Q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ILSGGSE MQTPGANSYG </a:t>
            </a:r>
            <a:r>
              <a:rPr b="0" lang="en-US" sz="1600" spc="-1" strike="noStrike">
                <a:solidFill>
                  <a:srgbClr val="ff0000"/>
                </a:solidFill>
                <a:latin typeface="Arial"/>
              </a:rPr>
              <a:t>ANSGHQR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AD SGMFLSFSEK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TQVQTN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DI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ESWKVHPR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D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EVDPDGWVVE IHLRNDQK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TK DKILERSRSW QTSYNKDDDP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51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K</a:t>
            </a:r>
            <a:r>
              <a:rPr b="1" lang="en-US" sz="1600" spc="-1" strike="noStrike">
                <a:solidFill>
                  <a:srgbClr val="ff0000"/>
                </a:solidFill>
                <a:latin typeface="Arial"/>
              </a:rPr>
              <a:t>FRFWYVCLW RER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RIPLTT SA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marL="343080" indent="0">
              <a:lnSpc>
                <a:spcPct val="8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27T05:32:18Z</dcterms:created>
  <dc:creator>微软用户</dc:creator>
  <dc:description/>
  <dc:language>en-US</dc:language>
  <cp:lastModifiedBy>微软用户</cp:lastModifiedBy>
  <dcterms:modified xsi:type="dcterms:W3CDTF">2010-07-18T06:23:56Z</dcterms:modified>
  <cp:revision>14</cp:revision>
  <dc:subject/>
  <dc:title>Annotated spectra for 32 differentially expressed proteins identified by PMF  </dc:title>
</cp:coreProperties>
</file>